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9" r:id="rId3"/>
    <p:sldId id="257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283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20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14\HOME\ABAHREYNI\oncolytic\cvb3-melittin\qpcr\melittin%20and%20intefron\12.1.21\hela.tretment.1DEC2021_Results_20211201%20160026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14\HOME\ABAHREYNI\oncolytic\cvb3-melittin\mice\tumor%20size\mir-tumor-chart%203%20(melanoma)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14\HOME\ABAHREYNI\oncolytic\cvb3-melittin\qpcr\melittin%20and%20intefron\DEC6-2021\IL6.10_Results_20211208%20095329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14\HOME\ABAHREYNI\oncolytic\cvb3-melittin\mice\tumor%20size\mir-tumor-char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14\HOME\ABAHREYNI\oncolytic\cvb3-melittin\mice\tumor%20size\mir-tumor-char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14\HOME\ABAHREYNI\oncolytic\cvb3-melittin\mice\tumor%20size\mir-tumor-chart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14\HOME\ABAHREYNI\oncolytic\cvb3-melittin\mice\tumor%20size\mir-tumor-chart2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14\HOME\ABAHREYNI\oncolytic\cvb3-melittin\mice\tumor%20size\mir-tumor-chart2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14\HOME\ABAHREYNI\oncolytic\cvb3-melittin\mice\tumor%20size\mir-tumor-chart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14\HOME\ABAHREYNI\oncolytic\cvb3-melittin\mice\tumor%20size\mir-tumor-chart2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000" dirty="0"/>
              <a:t>TNF-</a:t>
            </a:r>
            <a:r>
              <a:rPr lang="el-GR" sz="1000" dirty="0"/>
              <a:t>α</a:t>
            </a:r>
            <a:endParaRPr lang="en-US" sz="1000" dirty="0"/>
          </a:p>
        </c:rich>
      </c:tx>
      <c:layout>
        <c:manualLayout>
          <c:xMode val="edge"/>
          <c:yMode val="edge"/>
          <c:x val="0.29023295102923974"/>
          <c:y val="1.768670029770291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5915610022721419"/>
          <c:y val="7.1955624486749137E-2"/>
          <c:w val="0.67773887982943126"/>
          <c:h val="0.5123637462566632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7F1-BA41-A472-3BF0558847BC}"/>
              </c:ext>
            </c:extLst>
          </c:dPt>
          <c:dPt>
            <c:idx val="1"/>
            <c:invertIfNegative val="0"/>
            <c:bubble3D val="0"/>
            <c:spPr>
              <a:solidFill>
                <a:srgbClr val="0070C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77F1-BA41-A472-3BF0558847BC}"/>
              </c:ext>
            </c:extLst>
          </c:dPt>
          <c:dPt>
            <c:idx val="2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77F1-BA41-A472-3BF0558847BC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77F1-BA41-A472-3BF0558847BC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V$61:$V$64</c:f>
                <c:numCache>
                  <c:formatCode>General</c:formatCode>
                  <c:ptCount val="4"/>
                  <c:pt idx="0">
                    <c:v>0.27041571763636929</c:v>
                  </c:pt>
                  <c:pt idx="1">
                    <c:v>0.44205474378869375</c:v>
                  </c:pt>
                  <c:pt idx="2">
                    <c:v>0.65288013568330017</c:v>
                  </c:pt>
                  <c:pt idx="3">
                    <c:v>2.1777903849362685</c:v>
                  </c:pt>
                </c:numCache>
              </c:numRef>
            </c:plus>
            <c:minus>
              <c:numRef>
                <c:f>Sheet1!$V$61:$V$64</c:f>
                <c:numCache>
                  <c:formatCode>General</c:formatCode>
                  <c:ptCount val="4"/>
                  <c:pt idx="0">
                    <c:v>0.27041571763636929</c:v>
                  </c:pt>
                  <c:pt idx="1">
                    <c:v>0.44205474378869375</c:v>
                  </c:pt>
                  <c:pt idx="2">
                    <c:v>0.65288013568330017</c:v>
                  </c:pt>
                  <c:pt idx="3">
                    <c:v>2.17779038493626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T$61:$T$64</c:f>
              <c:strCache>
                <c:ptCount val="4"/>
                <c:pt idx="0">
                  <c:v>Sham</c:v>
                </c:pt>
                <c:pt idx="1">
                  <c:v>CpGMel</c:v>
                </c:pt>
                <c:pt idx="2">
                  <c:v>miR-CVB3</c:v>
                </c:pt>
                <c:pt idx="3">
                  <c:v>miR-CVB3+CpGMel</c:v>
                </c:pt>
              </c:strCache>
            </c:strRef>
          </c:cat>
          <c:val>
            <c:numRef>
              <c:f>Sheet1!$U$61:$U$64</c:f>
              <c:numCache>
                <c:formatCode>General</c:formatCode>
                <c:ptCount val="4"/>
                <c:pt idx="0">
                  <c:v>1.0180615040591054</c:v>
                </c:pt>
                <c:pt idx="1">
                  <c:v>2.922843560373193</c:v>
                </c:pt>
                <c:pt idx="2">
                  <c:v>7.8076353063437303</c:v>
                </c:pt>
                <c:pt idx="3">
                  <c:v>11.1008064162648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77F1-BA41-A472-3BF0558847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7764704"/>
        <c:axId val="317765096"/>
      </c:barChart>
      <c:catAx>
        <c:axId val="317764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765096"/>
        <c:crosses val="autoZero"/>
        <c:auto val="1"/>
        <c:lblAlgn val="ctr"/>
        <c:lblOffset val="100"/>
        <c:noMultiLvlLbl val="0"/>
      </c:catAx>
      <c:valAx>
        <c:axId val="3177650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800" dirty="0"/>
                  <a:t>Relative fold chan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764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888556009242045"/>
          <c:y val="5.0925925925925923E-2"/>
          <c:w val="0.82379353989160176"/>
          <c:h val="0.76680309307166095"/>
        </c:manualLayout>
      </c:layout>
      <c:scatterChart>
        <c:scatterStyle val="lineMarker"/>
        <c:varyColors val="0"/>
        <c:ser>
          <c:idx val="0"/>
          <c:order val="0"/>
          <c:tx>
            <c:v>Sham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AL$43:$AS$43</c:f>
                <c:numCache>
                  <c:formatCode>General</c:formatCode>
                  <c:ptCount val="8"/>
                  <c:pt idx="0">
                    <c:v>0.41633319989322704</c:v>
                  </c:pt>
                  <c:pt idx="1">
                    <c:v>0.41633319989322709</c:v>
                  </c:pt>
                  <c:pt idx="2">
                    <c:v>0.37859388972001834</c:v>
                  </c:pt>
                  <c:pt idx="3">
                    <c:v>0.40414518843273767</c:v>
                  </c:pt>
                  <c:pt idx="4">
                    <c:v>0.49328828623162357</c:v>
                  </c:pt>
                  <c:pt idx="5">
                    <c:v>0.43588989435406744</c:v>
                  </c:pt>
                  <c:pt idx="6">
                    <c:v>0.36055512754639862</c:v>
                  </c:pt>
                  <c:pt idx="7">
                    <c:v>0.30000000000000071</c:v>
                  </c:pt>
                </c:numCache>
              </c:numRef>
            </c:plus>
            <c:minus>
              <c:numRef>
                <c:f>Sheet2!$AL$43:$AS$43</c:f>
                <c:numCache>
                  <c:formatCode>General</c:formatCode>
                  <c:ptCount val="8"/>
                  <c:pt idx="0">
                    <c:v>0.41633319989322704</c:v>
                  </c:pt>
                  <c:pt idx="1">
                    <c:v>0.41633319989322709</c:v>
                  </c:pt>
                  <c:pt idx="2">
                    <c:v>0.37859388972001834</c:v>
                  </c:pt>
                  <c:pt idx="3">
                    <c:v>0.40414518843273767</c:v>
                  </c:pt>
                  <c:pt idx="4">
                    <c:v>0.49328828623162357</c:v>
                  </c:pt>
                  <c:pt idx="5">
                    <c:v>0.43588989435406744</c:v>
                  </c:pt>
                  <c:pt idx="6">
                    <c:v>0.36055512754639862</c:v>
                  </c:pt>
                  <c:pt idx="7">
                    <c:v>0.300000000000000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AA$42:$AH$42</c:f>
              <c:numCache>
                <c:formatCode>General</c:formatCode>
                <c:ptCount val="8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</c:numCache>
            </c:numRef>
          </c:xVal>
          <c:yVal>
            <c:numRef>
              <c:f>Sheet2!$AA$43:$AH$43</c:f>
              <c:numCache>
                <c:formatCode>General</c:formatCode>
                <c:ptCount val="8"/>
                <c:pt idx="0">
                  <c:v>17.133333333333336</c:v>
                </c:pt>
                <c:pt idx="1">
                  <c:v>17.333333333333332</c:v>
                </c:pt>
                <c:pt idx="2">
                  <c:v>17.566666666666666</c:v>
                </c:pt>
                <c:pt idx="3">
                  <c:v>17.733333333333334</c:v>
                </c:pt>
                <c:pt idx="4">
                  <c:v>17.833333333333332</c:v>
                </c:pt>
                <c:pt idx="5">
                  <c:v>18</c:v>
                </c:pt>
                <c:pt idx="6">
                  <c:v>18.099999999999998</c:v>
                </c:pt>
                <c:pt idx="7">
                  <c:v>18.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FDF7-7941-A54D-676E21D3DAE1}"/>
            </c:ext>
          </c:extLst>
        </c:ser>
        <c:ser>
          <c:idx val="1"/>
          <c:order val="1"/>
          <c:tx>
            <c:v>CpGMel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AL$45:$AS$45</c:f>
                <c:numCache>
                  <c:formatCode>General</c:formatCode>
                  <c:ptCount val="8"/>
                  <c:pt idx="0">
                    <c:v>0.55075705472860981</c:v>
                  </c:pt>
                  <c:pt idx="1">
                    <c:v>0.43588989435406744</c:v>
                  </c:pt>
                  <c:pt idx="2">
                    <c:v>0.37859388972001956</c:v>
                  </c:pt>
                  <c:pt idx="3">
                    <c:v>0.45825756949558316</c:v>
                  </c:pt>
                  <c:pt idx="4">
                    <c:v>0.47258156262526013</c:v>
                  </c:pt>
                  <c:pt idx="5">
                    <c:v>0.47258156262526158</c:v>
                  </c:pt>
                  <c:pt idx="6">
                    <c:v>0.51316014394468834</c:v>
                  </c:pt>
                  <c:pt idx="7">
                    <c:v>0.40414518843273833</c:v>
                  </c:pt>
                </c:numCache>
              </c:numRef>
            </c:plus>
            <c:minus>
              <c:numRef>
                <c:f>Sheet2!$AL$45:$AS$45</c:f>
                <c:numCache>
                  <c:formatCode>General</c:formatCode>
                  <c:ptCount val="8"/>
                  <c:pt idx="0">
                    <c:v>0.55075705472860981</c:v>
                  </c:pt>
                  <c:pt idx="1">
                    <c:v>0.43588989435406744</c:v>
                  </c:pt>
                  <c:pt idx="2">
                    <c:v>0.37859388972001956</c:v>
                  </c:pt>
                  <c:pt idx="3">
                    <c:v>0.45825756949558316</c:v>
                  </c:pt>
                  <c:pt idx="4">
                    <c:v>0.47258156262526013</c:v>
                  </c:pt>
                  <c:pt idx="5">
                    <c:v>0.47258156262526158</c:v>
                  </c:pt>
                  <c:pt idx="6">
                    <c:v>0.51316014394468834</c:v>
                  </c:pt>
                  <c:pt idx="7">
                    <c:v>0.404145188432738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AA$42:$AH$42</c:f>
              <c:numCache>
                <c:formatCode>General</c:formatCode>
                <c:ptCount val="8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</c:numCache>
            </c:numRef>
          </c:xVal>
          <c:yVal>
            <c:numRef>
              <c:f>Sheet2!$AA$44:$AH$44</c:f>
              <c:numCache>
                <c:formatCode>General</c:formatCode>
                <c:ptCount val="8"/>
                <c:pt idx="0">
                  <c:v>17.266666666666666</c:v>
                </c:pt>
                <c:pt idx="1">
                  <c:v>17.433333333333334</c:v>
                </c:pt>
                <c:pt idx="2">
                  <c:v>17.566666666666666</c:v>
                </c:pt>
                <c:pt idx="3">
                  <c:v>17.733333333333334</c:v>
                </c:pt>
                <c:pt idx="4">
                  <c:v>17.8</c:v>
                </c:pt>
                <c:pt idx="5">
                  <c:v>17.933333333333334</c:v>
                </c:pt>
                <c:pt idx="6">
                  <c:v>18.033333333333335</c:v>
                </c:pt>
                <c:pt idx="7">
                  <c:v>18.13333333333333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FDF7-7941-A54D-676E21D3DAE1}"/>
            </c:ext>
          </c:extLst>
        </c:ser>
        <c:ser>
          <c:idx val="2"/>
          <c:order val="2"/>
          <c:tx>
            <c:v>miR-CVB3</c:v>
          </c:tx>
          <c:spPr>
            <a:ln w="19050" cap="rnd">
              <a:solidFill>
                <a:srgbClr val="7030A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AL$45:$AS$45</c:f>
                <c:numCache>
                  <c:formatCode>General</c:formatCode>
                  <c:ptCount val="8"/>
                  <c:pt idx="0">
                    <c:v>0.55075705472860981</c:v>
                  </c:pt>
                  <c:pt idx="1">
                    <c:v>0.43588989435406744</c:v>
                  </c:pt>
                  <c:pt idx="2">
                    <c:v>0.37859388972001956</c:v>
                  </c:pt>
                  <c:pt idx="3">
                    <c:v>0.45825756949558316</c:v>
                  </c:pt>
                  <c:pt idx="4">
                    <c:v>0.47258156262526013</c:v>
                  </c:pt>
                  <c:pt idx="5">
                    <c:v>0.47258156262526158</c:v>
                  </c:pt>
                  <c:pt idx="6">
                    <c:v>0.51316014394468834</c:v>
                  </c:pt>
                  <c:pt idx="7">
                    <c:v>0.40414518843273833</c:v>
                  </c:pt>
                </c:numCache>
              </c:numRef>
            </c:plus>
            <c:minus>
              <c:numRef>
                <c:f>Sheet2!$AL$45:$AS$45</c:f>
                <c:numCache>
                  <c:formatCode>General</c:formatCode>
                  <c:ptCount val="8"/>
                  <c:pt idx="0">
                    <c:v>0.55075705472860981</c:v>
                  </c:pt>
                  <c:pt idx="1">
                    <c:v>0.43588989435406744</c:v>
                  </c:pt>
                  <c:pt idx="2">
                    <c:v>0.37859388972001956</c:v>
                  </c:pt>
                  <c:pt idx="3">
                    <c:v>0.45825756949558316</c:v>
                  </c:pt>
                  <c:pt idx="4">
                    <c:v>0.47258156262526013</c:v>
                  </c:pt>
                  <c:pt idx="5">
                    <c:v>0.47258156262526158</c:v>
                  </c:pt>
                  <c:pt idx="6">
                    <c:v>0.51316014394468834</c:v>
                  </c:pt>
                  <c:pt idx="7">
                    <c:v>0.404145188432738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AA$42:$AH$42</c:f>
              <c:numCache>
                <c:formatCode>General</c:formatCode>
                <c:ptCount val="8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</c:numCache>
            </c:numRef>
          </c:xVal>
          <c:yVal>
            <c:numRef>
              <c:f>Sheet2!$AA$45:$AH$45</c:f>
              <c:numCache>
                <c:formatCode>General</c:formatCode>
                <c:ptCount val="8"/>
                <c:pt idx="0">
                  <c:v>17.266666666666666</c:v>
                </c:pt>
                <c:pt idx="1">
                  <c:v>17.5</c:v>
                </c:pt>
                <c:pt idx="2">
                  <c:v>17.666666666666668</c:v>
                </c:pt>
                <c:pt idx="3">
                  <c:v>17.900000000000002</c:v>
                </c:pt>
                <c:pt idx="4">
                  <c:v>18.166666666666668</c:v>
                </c:pt>
                <c:pt idx="5">
                  <c:v>18.266666666666669</c:v>
                </c:pt>
                <c:pt idx="6">
                  <c:v>18.433333333333334</c:v>
                </c:pt>
                <c:pt idx="7">
                  <c:v>18.56666666666666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FDF7-7941-A54D-676E21D3DAE1}"/>
            </c:ext>
          </c:extLst>
        </c:ser>
        <c:ser>
          <c:idx val="3"/>
          <c:order val="3"/>
          <c:tx>
            <c:v>miR-CVB3+CpGMel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AL$46:$AS$46</c:f>
                <c:numCache>
                  <c:formatCode>General</c:formatCode>
                  <c:ptCount val="8"/>
                  <c:pt idx="0">
                    <c:v>0.65064070986477152</c:v>
                  </c:pt>
                  <c:pt idx="1">
                    <c:v>0.55677643628300311</c:v>
                  </c:pt>
                  <c:pt idx="2">
                    <c:v>0.61101009266077844</c:v>
                  </c:pt>
                  <c:pt idx="3">
                    <c:v>0.62449979983983928</c:v>
                  </c:pt>
                  <c:pt idx="4">
                    <c:v>0.58594652770823241</c:v>
                  </c:pt>
                  <c:pt idx="5">
                    <c:v>0.57735026918962584</c:v>
                  </c:pt>
                  <c:pt idx="6">
                    <c:v>0.57735026918962584</c:v>
                  </c:pt>
                  <c:pt idx="7">
                    <c:v>0.52915026221291828</c:v>
                  </c:pt>
                </c:numCache>
              </c:numRef>
            </c:plus>
            <c:minus>
              <c:numRef>
                <c:f>Sheet2!$AL$46:$AS$46</c:f>
                <c:numCache>
                  <c:formatCode>General</c:formatCode>
                  <c:ptCount val="8"/>
                  <c:pt idx="0">
                    <c:v>0.65064070986477152</c:v>
                  </c:pt>
                  <c:pt idx="1">
                    <c:v>0.55677643628300311</c:v>
                  </c:pt>
                  <c:pt idx="2">
                    <c:v>0.61101009266077844</c:v>
                  </c:pt>
                  <c:pt idx="3">
                    <c:v>0.62449979983983928</c:v>
                  </c:pt>
                  <c:pt idx="4">
                    <c:v>0.58594652770823241</c:v>
                  </c:pt>
                  <c:pt idx="5">
                    <c:v>0.57735026918962584</c:v>
                  </c:pt>
                  <c:pt idx="6">
                    <c:v>0.57735026918962584</c:v>
                  </c:pt>
                  <c:pt idx="7">
                    <c:v>0.529150262212918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AA$42:$AH$42</c:f>
              <c:numCache>
                <c:formatCode>General</c:formatCode>
                <c:ptCount val="8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</c:numCache>
            </c:numRef>
          </c:xVal>
          <c:yVal>
            <c:numRef>
              <c:f>Sheet2!$AA$46:$AH$46</c:f>
              <c:numCache>
                <c:formatCode>General</c:formatCode>
                <c:ptCount val="8"/>
                <c:pt idx="0">
                  <c:v>17.333333333333332</c:v>
                </c:pt>
                <c:pt idx="1">
                  <c:v>17.5</c:v>
                </c:pt>
                <c:pt idx="2">
                  <c:v>17.633333333333336</c:v>
                </c:pt>
                <c:pt idx="3">
                  <c:v>17.8</c:v>
                </c:pt>
                <c:pt idx="4">
                  <c:v>17.933333333333334</c:v>
                </c:pt>
                <c:pt idx="5">
                  <c:v>18.033333333333331</c:v>
                </c:pt>
                <c:pt idx="6">
                  <c:v>18.233333333333331</c:v>
                </c:pt>
                <c:pt idx="7">
                  <c:v>18.40000000000000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FDF7-7941-A54D-676E21D3DA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9014648"/>
        <c:axId val="299009552"/>
      </c:scatterChart>
      <c:valAx>
        <c:axId val="299014648"/>
        <c:scaling>
          <c:orientation val="minMax"/>
          <c:max val="14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9009552"/>
        <c:crosses val="autoZero"/>
        <c:crossBetween val="midCat"/>
      </c:valAx>
      <c:valAx>
        <c:axId val="299009552"/>
        <c:scaling>
          <c:orientation val="minMax"/>
          <c:max val="20"/>
          <c:min val="1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Body weight (g)</a:t>
                </a:r>
              </a:p>
            </c:rich>
          </c:tx>
          <c:layout>
            <c:manualLayout>
              <c:xMode val="edge"/>
              <c:yMode val="edge"/>
              <c:x val="2.4073424555716049E-2"/>
              <c:y val="0.2213506283452038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901464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6091471426270515"/>
          <c:y val="2.4074023982471947E-3"/>
          <c:w val="0.40922410608741105"/>
          <c:h val="0.338057973245998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IL-6</a:t>
            </a:r>
          </a:p>
        </c:rich>
      </c:tx>
      <c:layout>
        <c:manualLayout>
          <c:xMode val="edge"/>
          <c:yMode val="edge"/>
          <c:x val="0.23632991461314753"/>
          <c:y val="2.34687126949104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972528756153425"/>
          <c:y val="5.0925925925925923E-2"/>
          <c:w val="0.8197191937702667"/>
          <c:h val="0.555085873313301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A6E-4545-8F20-C77F4C15827D}"/>
              </c:ext>
            </c:extLst>
          </c:dPt>
          <c:dPt>
            <c:idx val="1"/>
            <c:invertIfNegative val="0"/>
            <c:bubble3D val="0"/>
            <c:spPr>
              <a:solidFill>
                <a:srgbClr val="0070C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2A6E-4545-8F20-C77F4C15827D}"/>
              </c:ext>
            </c:extLst>
          </c:dPt>
          <c:dPt>
            <c:idx val="2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2A6E-4545-8F20-C77F4C15827D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2A6E-4545-8F20-C77F4C15827D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22:$L$25</c:f>
                <c:numCache>
                  <c:formatCode>General</c:formatCode>
                  <c:ptCount val="4"/>
                  <c:pt idx="0">
                    <c:v>0.17508118724567226</c:v>
                  </c:pt>
                  <c:pt idx="1">
                    <c:v>4.8183901572751639E-2</c:v>
                  </c:pt>
                  <c:pt idx="2">
                    <c:v>0.29801229168554227</c:v>
                  </c:pt>
                  <c:pt idx="3">
                    <c:v>1.670978536547143</c:v>
                  </c:pt>
                </c:numCache>
              </c:numRef>
            </c:plus>
            <c:minus>
              <c:numRef>
                <c:f>Sheet1!$L$22:$L$25</c:f>
                <c:numCache>
                  <c:formatCode>General</c:formatCode>
                  <c:ptCount val="4"/>
                  <c:pt idx="0">
                    <c:v>0.17508118724567226</c:v>
                  </c:pt>
                  <c:pt idx="1">
                    <c:v>4.8183901572751639E-2</c:v>
                  </c:pt>
                  <c:pt idx="2">
                    <c:v>0.29801229168554227</c:v>
                  </c:pt>
                  <c:pt idx="3">
                    <c:v>1.6709785365471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J$22:$J$25</c:f>
              <c:strCache>
                <c:ptCount val="4"/>
                <c:pt idx="0">
                  <c:v>Sham</c:v>
                </c:pt>
                <c:pt idx="1">
                  <c:v>CpGMel</c:v>
                </c:pt>
                <c:pt idx="2">
                  <c:v>miR-CVB3</c:v>
                </c:pt>
                <c:pt idx="3">
                  <c:v>miR-CVB3+CpGMel</c:v>
                </c:pt>
              </c:strCache>
            </c:strRef>
          </c:cat>
          <c:val>
            <c:numRef>
              <c:f>Sheet1!$K$22:$K$25</c:f>
              <c:numCache>
                <c:formatCode>General</c:formatCode>
                <c:ptCount val="4"/>
                <c:pt idx="0">
                  <c:v>1.0112604835005756</c:v>
                </c:pt>
                <c:pt idx="1">
                  <c:v>0.73894558003018906</c:v>
                </c:pt>
                <c:pt idx="2">
                  <c:v>2.352668733253656</c:v>
                </c:pt>
                <c:pt idx="3">
                  <c:v>4.99560987441005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2A6E-4545-8F20-C77F4C1582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7766272"/>
        <c:axId val="317761568"/>
      </c:barChart>
      <c:catAx>
        <c:axId val="317766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761568"/>
        <c:crosses val="autoZero"/>
        <c:auto val="1"/>
        <c:lblAlgn val="ctr"/>
        <c:lblOffset val="100"/>
        <c:noMultiLvlLbl val="0"/>
      </c:catAx>
      <c:valAx>
        <c:axId val="3177615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766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</a:defRPr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>
                <a:solidFill>
                  <a:schemeClr val="tx1"/>
                </a:solidFill>
              </a:rPr>
              <a:t>Sham</a:t>
            </a:r>
          </a:p>
        </c:rich>
      </c:tx>
      <c:layout>
        <c:manualLayout>
          <c:xMode val="edge"/>
          <c:yMode val="edge"/>
          <c:x val="0.42371226289334168"/>
          <c:y val="5.752779944087810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4016245705044174"/>
          <c:y val="0.10457980170273228"/>
          <c:w val="0.57241502489786955"/>
          <c:h val="0.60177551021948883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cat>
            <c:numRef>
              <c:f>Sheet1!$E$81:$M$81</c:f>
              <c:numCache>
                <c:formatCode>General</c:formatCode>
                <c:ptCount val="9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</c:numCache>
            </c:numRef>
          </c:cat>
          <c:val>
            <c:numRef>
              <c:f>Sheet1!$AI$82:$AP$82</c:f>
              <c:numCache>
                <c:formatCode>General</c:formatCode>
                <c:ptCount val="8"/>
                <c:pt idx="0">
                  <c:v>63.881999999999998</c:v>
                </c:pt>
                <c:pt idx="1">
                  <c:v>98.736000000000018</c:v>
                </c:pt>
                <c:pt idx="2">
                  <c:v>147.5</c:v>
                </c:pt>
                <c:pt idx="3">
                  <c:v>199.64999999999998</c:v>
                </c:pt>
                <c:pt idx="4">
                  <c:v>255.59999999999997</c:v>
                </c:pt>
                <c:pt idx="5">
                  <c:v>335.41199999999998</c:v>
                </c:pt>
                <c:pt idx="6">
                  <c:v>431.64899999999994</c:v>
                </c:pt>
                <c:pt idx="7">
                  <c:v>610.17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E00-EA41-9308-9C250967C4D9}"/>
            </c:ext>
          </c:extLst>
        </c:ser>
        <c:ser>
          <c:idx val="1"/>
          <c:order val="1"/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val>
            <c:numRef>
              <c:f>Sheet1!$AI$83:$AQ$83</c:f>
              <c:numCache>
                <c:formatCode>General</c:formatCode>
                <c:ptCount val="9"/>
                <c:pt idx="0">
                  <c:v>62.4</c:v>
                </c:pt>
                <c:pt idx="1">
                  <c:v>83.204999999999984</c:v>
                </c:pt>
                <c:pt idx="2">
                  <c:v>130</c:v>
                </c:pt>
                <c:pt idx="3">
                  <c:v>226.98099999999994</c:v>
                </c:pt>
                <c:pt idx="4">
                  <c:v>323.68</c:v>
                </c:pt>
                <c:pt idx="5">
                  <c:v>438.08000000000004</c:v>
                </c:pt>
                <c:pt idx="6">
                  <c:v>537.6</c:v>
                </c:pt>
                <c:pt idx="7">
                  <c:v>769.5</c:v>
                </c:pt>
                <c:pt idx="8">
                  <c:v>846.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3E00-EA41-9308-9C250967C4D9}"/>
            </c:ext>
          </c:extLst>
        </c:ser>
        <c:ser>
          <c:idx val="2"/>
          <c:order val="2"/>
          <c:tx>
            <c:strRef>
              <c:f>Sheet1!$E$84:$M$84</c:f>
              <c:strCache>
                <c:ptCount val="9"/>
                <c:pt idx="0">
                  <c:v>24.5</c:v>
                </c:pt>
                <c:pt idx="1">
                  <c:v>39.5035</c:v>
                </c:pt>
                <c:pt idx="2">
                  <c:v>59.643</c:v>
                </c:pt>
                <c:pt idx="3">
                  <c:v>111.392</c:v>
                </c:pt>
                <c:pt idx="4">
                  <c:v>168.776</c:v>
                </c:pt>
                <c:pt idx="5">
                  <c:v>189.0375</c:v>
                </c:pt>
                <c:pt idx="6">
                  <c:v>262.122</c:v>
                </c:pt>
                <c:pt idx="7">
                  <c:v>380.208</c:v>
                </c:pt>
                <c:pt idx="8">
                  <c:v>392.0895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val>
            <c:numRef>
              <c:f>Sheet1!$AI$84:$AQ$84</c:f>
              <c:numCache>
                <c:formatCode>General</c:formatCode>
                <c:ptCount val="9"/>
                <c:pt idx="0">
                  <c:v>49</c:v>
                </c:pt>
                <c:pt idx="1">
                  <c:v>79.006999999999991</c:v>
                </c:pt>
                <c:pt idx="2">
                  <c:v>119.28600000000002</c:v>
                </c:pt>
                <c:pt idx="3">
                  <c:v>222.78400000000005</c:v>
                </c:pt>
                <c:pt idx="4">
                  <c:v>337.55200000000002</c:v>
                </c:pt>
                <c:pt idx="5">
                  <c:v>378.07499999999999</c:v>
                </c:pt>
                <c:pt idx="6">
                  <c:v>524.24400000000003</c:v>
                </c:pt>
                <c:pt idx="7">
                  <c:v>760.41600000000005</c:v>
                </c:pt>
                <c:pt idx="8">
                  <c:v>784.179000000000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3E00-EA41-9308-9C250967C4D9}"/>
            </c:ext>
          </c:extLst>
        </c:ser>
        <c:ser>
          <c:idx val="3"/>
          <c:order val="3"/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val>
            <c:numRef>
              <c:f>Sheet1!$AI$85:$AQ$85</c:f>
              <c:numCache>
                <c:formatCode>General</c:formatCode>
                <c:ptCount val="9"/>
                <c:pt idx="0">
                  <c:v>50.543999999999997</c:v>
                </c:pt>
                <c:pt idx="1">
                  <c:v>85.184000000000026</c:v>
                </c:pt>
                <c:pt idx="2">
                  <c:v>117.50399999999998</c:v>
                </c:pt>
                <c:pt idx="3">
                  <c:v>211.18500000000003</c:v>
                </c:pt>
                <c:pt idx="4">
                  <c:v>309.27599999999995</c:v>
                </c:pt>
                <c:pt idx="5">
                  <c:v>388.15699999999998</c:v>
                </c:pt>
                <c:pt idx="6">
                  <c:v>505.52100000000002</c:v>
                </c:pt>
                <c:pt idx="7">
                  <c:v>686.375</c:v>
                </c:pt>
                <c:pt idx="8">
                  <c:v>848.2559999999999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3E00-EA41-9308-9C250967C4D9}"/>
            </c:ext>
          </c:extLst>
        </c:ser>
        <c:ser>
          <c:idx val="4"/>
          <c:order val="4"/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val>
            <c:numRef>
              <c:f>Sheet1!$AI$86:$AP$86</c:f>
              <c:numCache>
                <c:formatCode>General</c:formatCode>
                <c:ptCount val="8"/>
                <c:pt idx="0">
                  <c:v>65.599999999999994</c:v>
                </c:pt>
                <c:pt idx="1">
                  <c:v>86.436000000000007</c:v>
                </c:pt>
                <c:pt idx="2">
                  <c:v>132.05500000000004</c:v>
                </c:pt>
                <c:pt idx="3">
                  <c:v>244.79999999999998</c:v>
                </c:pt>
                <c:pt idx="4">
                  <c:v>311.29600000000005</c:v>
                </c:pt>
                <c:pt idx="5">
                  <c:v>392</c:v>
                </c:pt>
                <c:pt idx="6">
                  <c:v>485.18399999999997</c:v>
                </c:pt>
                <c:pt idx="7">
                  <c:v>696.9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3E00-EA41-9308-9C250967C4D9}"/>
            </c:ext>
          </c:extLst>
        </c:ser>
        <c:ser>
          <c:idx val="5"/>
          <c:order val="5"/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val>
            <c:numRef>
              <c:f>Sheet1!$AI$87:$AP$87</c:f>
              <c:numCache>
                <c:formatCode>General</c:formatCode>
                <c:ptCount val="8"/>
                <c:pt idx="0">
                  <c:v>52.022000000000006</c:v>
                </c:pt>
                <c:pt idx="1">
                  <c:v>65.402999999999992</c:v>
                </c:pt>
                <c:pt idx="2">
                  <c:v>105.8</c:v>
                </c:pt>
                <c:pt idx="3">
                  <c:v>226.79999999999998</c:v>
                </c:pt>
                <c:pt idx="4">
                  <c:v>309.74100000000004</c:v>
                </c:pt>
                <c:pt idx="5">
                  <c:v>405.00399999999996</c:v>
                </c:pt>
                <c:pt idx="6">
                  <c:v>499.28000000000003</c:v>
                </c:pt>
                <c:pt idx="7">
                  <c:v>778.4139999999999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3E00-EA41-9308-9C250967C4D9}"/>
            </c:ext>
          </c:extLst>
        </c:ser>
        <c:ser>
          <c:idx val="6"/>
          <c:order val="6"/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val>
            <c:numRef>
              <c:f>Sheet1!$AI$88:$AP$88</c:f>
              <c:numCache>
                <c:formatCode>General</c:formatCode>
                <c:ptCount val="8"/>
                <c:pt idx="0">
                  <c:v>46.239999999999995</c:v>
                </c:pt>
                <c:pt idx="1">
                  <c:v>73.007999999999996</c:v>
                </c:pt>
                <c:pt idx="2">
                  <c:v>106.48000000000002</c:v>
                </c:pt>
                <c:pt idx="3">
                  <c:v>234.42299999999997</c:v>
                </c:pt>
                <c:pt idx="4">
                  <c:v>314.43199999999996</c:v>
                </c:pt>
                <c:pt idx="5">
                  <c:v>394.346</c:v>
                </c:pt>
                <c:pt idx="6">
                  <c:v>480.63600000000002</c:v>
                </c:pt>
                <c:pt idx="7">
                  <c:v>921.5999999999999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3E00-EA41-9308-9C250967C4D9}"/>
            </c:ext>
          </c:extLst>
        </c:ser>
        <c:ser>
          <c:idx val="7"/>
          <c:order val="7"/>
          <c:tx>
            <c:strRef>
              <c:f>Sheet1!$E$89:$L$89</c:f>
              <c:strCache>
                <c:ptCount val="8"/>
                <c:pt idx="0">
                  <c:v>23.328</c:v>
                </c:pt>
                <c:pt idx="1">
                  <c:v>32.8</c:v>
                </c:pt>
                <c:pt idx="2">
                  <c:v>54.1205</c:v>
                </c:pt>
                <c:pt idx="3">
                  <c:v>104.43</c:v>
                </c:pt>
                <c:pt idx="4">
                  <c:v>154.8705</c:v>
                </c:pt>
                <c:pt idx="5">
                  <c:v>205.1665</c:v>
                </c:pt>
                <c:pt idx="6">
                  <c:v>240.318</c:v>
                </c:pt>
                <c:pt idx="7">
                  <c:v>371.712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val>
            <c:numRef>
              <c:f>Sheet1!$AI$89:$AP$89</c:f>
              <c:numCache>
                <c:formatCode>General</c:formatCode>
                <c:ptCount val="8"/>
                <c:pt idx="0">
                  <c:v>46.656000000000006</c:v>
                </c:pt>
                <c:pt idx="1">
                  <c:v>65.599999999999994</c:v>
                </c:pt>
                <c:pt idx="2">
                  <c:v>108.24100000000001</c:v>
                </c:pt>
                <c:pt idx="3">
                  <c:v>208.86000000000004</c:v>
                </c:pt>
                <c:pt idx="4">
                  <c:v>309.74100000000004</c:v>
                </c:pt>
                <c:pt idx="5">
                  <c:v>410.33299999999997</c:v>
                </c:pt>
                <c:pt idx="6">
                  <c:v>485.18399999999997</c:v>
                </c:pt>
                <c:pt idx="7">
                  <c:v>743.4240000000000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3E00-EA41-9308-9C250967C4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17767056"/>
        <c:axId val="317764312"/>
      </c:lineChart>
      <c:catAx>
        <c:axId val="3177670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764312"/>
        <c:crosses val="autoZero"/>
        <c:auto val="1"/>
        <c:lblAlgn val="ctr"/>
        <c:lblOffset val="100"/>
        <c:noMultiLvlLbl val="0"/>
      </c:catAx>
      <c:valAx>
        <c:axId val="3177643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1" dirty="0">
                    <a:solidFill>
                      <a:schemeClr val="tx1"/>
                    </a:solidFill>
                  </a:rPr>
                  <a:t>Tumor size (mm</a:t>
                </a:r>
                <a:r>
                  <a:rPr lang="en-US" sz="900" b="0" i="0" u="none" strike="noStrike" baseline="30000" dirty="0">
                    <a:effectLst/>
                  </a:rPr>
                  <a:t>3</a:t>
                </a:r>
                <a:r>
                  <a:rPr lang="en-US" sz="900" b="1" dirty="0">
                    <a:solidFill>
                      <a:schemeClr val="tx1"/>
                    </a:solidFill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1.6557295085547111E-2"/>
              <c:y val="8.540386855577289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767056"/>
        <c:crosses val="autoZero"/>
        <c:crossBetween val="midCat"/>
        <c:majorUnit val="2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chemeClr val="tx1"/>
                </a:solidFill>
              </a:rPr>
              <a:t>miR-CVB3</a:t>
            </a:r>
          </a:p>
        </c:rich>
      </c:tx>
      <c:layout>
        <c:manualLayout>
          <c:xMode val="edge"/>
          <c:yMode val="edge"/>
          <c:x val="0.41119341266573434"/>
          <c:y val="0.1370504924396025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3693564117467417"/>
          <c:y val="7.9477506962623928E-2"/>
          <c:w val="0.58049039986602169"/>
          <c:h val="0.66115884524037138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cat>
            <c:numRef>
              <c:f>Sheet1!$E$104:$P$104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</c:numCache>
            </c:numRef>
          </c:cat>
          <c:val>
            <c:numRef>
              <c:f>Sheet1!$AI$106:$AT$106</c:f>
              <c:numCache>
                <c:formatCode>General</c:formatCode>
                <c:ptCount val="12"/>
                <c:pt idx="0">
                  <c:v>59.318999999999996</c:v>
                </c:pt>
                <c:pt idx="1">
                  <c:v>81.356000000000009</c:v>
                </c:pt>
                <c:pt idx="2">
                  <c:v>108.24100000000001</c:v>
                </c:pt>
                <c:pt idx="3">
                  <c:v>122.45100000000001</c:v>
                </c:pt>
                <c:pt idx="4">
                  <c:v>154.49499999999998</c:v>
                </c:pt>
                <c:pt idx="5">
                  <c:v>194.94000000000003</c:v>
                </c:pt>
                <c:pt idx="6">
                  <c:v>234</c:v>
                </c:pt>
                <c:pt idx="7">
                  <c:v>295.75</c:v>
                </c:pt>
                <c:pt idx="8">
                  <c:v>305.613</c:v>
                </c:pt>
                <c:pt idx="9">
                  <c:v>369.91999999999996</c:v>
                </c:pt>
                <c:pt idx="10">
                  <c:v>465.46000000000004</c:v>
                </c:pt>
                <c:pt idx="11">
                  <c:v>535.3919999999999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74DF-D948-A39A-F5088C6883B0}"/>
            </c:ext>
          </c:extLst>
        </c:ser>
        <c:ser>
          <c:idx val="1"/>
          <c:order val="1"/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val>
            <c:numRef>
              <c:f>Sheet1!$AI$107:$AP$107</c:f>
              <c:numCache>
                <c:formatCode>General</c:formatCode>
                <c:ptCount val="8"/>
                <c:pt idx="0">
                  <c:v>54.432000000000002</c:v>
                </c:pt>
                <c:pt idx="1">
                  <c:v>62.974000000000004</c:v>
                </c:pt>
                <c:pt idx="2">
                  <c:v>78.400000000000006</c:v>
                </c:pt>
                <c:pt idx="3">
                  <c:v>102.608</c:v>
                </c:pt>
                <c:pt idx="4">
                  <c:v>125.91300000000001</c:v>
                </c:pt>
                <c:pt idx="5">
                  <c:v>152.5</c:v>
                </c:pt>
                <c:pt idx="6">
                  <c:v>185.39399999999998</c:v>
                </c:pt>
                <c:pt idx="7">
                  <c:v>255.5999999999999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4DF-D948-A39A-F5088C6883B0}"/>
            </c:ext>
          </c:extLst>
        </c:ser>
        <c:ser>
          <c:idx val="2"/>
          <c:order val="2"/>
          <c:tx>
            <c:strRef>
              <c:f>Sheet1!$AI$108:$AT$108</c:f>
              <c:strCache>
                <c:ptCount val="12"/>
                <c:pt idx="0">
                  <c:v>53.391</c:v>
                </c:pt>
                <c:pt idx="1">
                  <c:v>65.403</c:v>
                </c:pt>
                <c:pt idx="2">
                  <c:v>73.6</c:v>
                </c:pt>
                <c:pt idx="3">
                  <c:v>92.45</c:v>
                </c:pt>
                <c:pt idx="4">
                  <c:v>122.112</c:v>
                </c:pt>
                <c:pt idx="5">
                  <c:v>168.54</c:v>
                </c:pt>
                <c:pt idx="6">
                  <c:v>226.265</c:v>
                </c:pt>
                <c:pt idx="7">
                  <c:v>333.27</c:v>
                </c:pt>
                <c:pt idx="8">
                  <c:v>332.186</c:v>
                </c:pt>
                <c:pt idx="9">
                  <c:v>409.536</c:v>
                </c:pt>
                <c:pt idx="10">
                  <c:v>478.125</c:v>
                </c:pt>
                <c:pt idx="11">
                  <c:v>561.69</c:v>
                </c:pt>
              </c:strCache>
            </c:strRef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val>
            <c:numRef>
              <c:f>Sheet1!$AI$108:$AT$108</c:f>
              <c:numCache>
                <c:formatCode>General</c:formatCode>
                <c:ptCount val="12"/>
                <c:pt idx="0">
                  <c:v>53.390999999999998</c:v>
                </c:pt>
                <c:pt idx="1">
                  <c:v>65.402999999999992</c:v>
                </c:pt>
                <c:pt idx="2">
                  <c:v>73.599999999999994</c:v>
                </c:pt>
                <c:pt idx="3">
                  <c:v>92.45</c:v>
                </c:pt>
                <c:pt idx="4">
                  <c:v>122.11199999999998</c:v>
                </c:pt>
                <c:pt idx="5">
                  <c:v>168.54</c:v>
                </c:pt>
                <c:pt idx="6">
                  <c:v>226.26500000000001</c:v>
                </c:pt>
                <c:pt idx="7">
                  <c:v>333.27000000000004</c:v>
                </c:pt>
                <c:pt idx="8">
                  <c:v>332.18600000000004</c:v>
                </c:pt>
                <c:pt idx="9">
                  <c:v>409.536</c:v>
                </c:pt>
                <c:pt idx="10">
                  <c:v>478.125</c:v>
                </c:pt>
                <c:pt idx="11">
                  <c:v>561.6900000000000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74DF-D948-A39A-F5088C6883B0}"/>
            </c:ext>
          </c:extLst>
        </c:ser>
        <c:ser>
          <c:idx val="3"/>
          <c:order val="3"/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val>
            <c:numRef>
              <c:f>Sheet1!$AI$109:$AT$109</c:f>
              <c:numCache>
                <c:formatCode>General</c:formatCode>
                <c:ptCount val="12"/>
                <c:pt idx="0">
                  <c:v>54.760000000000005</c:v>
                </c:pt>
                <c:pt idx="1">
                  <c:v>56.129000000000005</c:v>
                </c:pt>
                <c:pt idx="2">
                  <c:v>68.445000000000007</c:v>
                </c:pt>
                <c:pt idx="3">
                  <c:v>107.32499999999999</c:v>
                </c:pt>
                <c:pt idx="4">
                  <c:v>111.375</c:v>
                </c:pt>
                <c:pt idx="5">
                  <c:v>152.5</c:v>
                </c:pt>
                <c:pt idx="6">
                  <c:v>200.70399999999998</c:v>
                </c:pt>
                <c:pt idx="7">
                  <c:v>286.72000000000003</c:v>
                </c:pt>
                <c:pt idx="8">
                  <c:v>356.048</c:v>
                </c:pt>
                <c:pt idx="9">
                  <c:v>408.32099999999997</c:v>
                </c:pt>
                <c:pt idx="10">
                  <c:v>472.5</c:v>
                </c:pt>
                <c:pt idx="11">
                  <c:v>569.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74DF-D948-A39A-F5088C6883B0}"/>
            </c:ext>
          </c:extLst>
        </c:ser>
        <c:ser>
          <c:idx val="4"/>
          <c:order val="4"/>
          <c:tx>
            <c:strRef>
              <c:f>Sheet1!$AI$110:$AS$110</c:f>
              <c:strCache>
                <c:ptCount val="11"/>
                <c:pt idx="0">
                  <c:v>57.76</c:v>
                </c:pt>
                <c:pt idx="1">
                  <c:v>68.8</c:v>
                </c:pt>
                <c:pt idx="2">
                  <c:v>88.752</c:v>
                </c:pt>
                <c:pt idx="3">
                  <c:v>98.736</c:v>
                </c:pt>
                <c:pt idx="4">
                  <c:v>140</c:v>
                </c:pt>
                <c:pt idx="5">
                  <c:v>171.349</c:v>
                </c:pt>
                <c:pt idx="6">
                  <c:v>241.2</c:v>
                </c:pt>
                <c:pt idx="7">
                  <c:v>317.988</c:v>
                </c:pt>
                <c:pt idx="8">
                  <c:v>392</c:v>
                </c:pt>
                <c:pt idx="9">
                  <c:v>438.08</c:v>
                </c:pt>
                <c:pt idx="10">
                  <c:v>496.736</c:v>
                </c:pt>
              </c:strCache>
            </c:strRef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val>
            <c:numRef>
              <c:f>Sheet1!$AI$110:$AS$110</c:f>
              <c:numCache>
                <c:formatCode>General</c:formatCode>
                <c:ptCount val="11"/>
                <c:pt idx="0">
                  <c:v>57.76</c:v>
                </c:pt>
                <c:pt idx="1">
                  <c:v>68.8</c:v>
                </c:pt>
                <c:pt idx="2">
                  <c:v>88.751999999999981</c:v>
                </c:pt>
                <c:pt idx="3">
                  <c:v>98.736000000000018</c:v>
                </c:pt>
                <c:pt idx="4">
                  <c:v>140</c:v>
                </c:pt>
                <c:pt idx="5">
                  <c:v>171.34899999999999</c:v>
                </c:pt>
                <c:pt idx="6">
                  <c:v>241.20000000000002</c:v>
                </c:pt>
                <c:pt idx="7">
                  <c:v>317.988</c:v>
                </c:pt>
                <c:pt idx="8">
                  <c:v>392</c:v>
                </c:pt>
                <c:pt idx="9">
                  <c:v>438.08000000000004</c:v>
                </c:pt>
                <c:pt idx="10">
                  <c:v>496.7359999999999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74DF-D948-A39A-F5088C6883B0}"/>
            </c:ext>
          </c:extLst>
        </c:ser>
        <c:ser>
          <c:idx val="5"/>
          <c:order val="5"/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val>
            <c:numRef>
              <c:f>Sheet1!$AI$111:$AS$111</c:f>
              <c:numCache>
                <c:formatCode>General</c:formatCode>
                <c:ptCount val="11"/>
                <c:pt idx="0">
                  <c:v>50.653000000000006</c:v>
                </c:pt>
                <c:pt idx="1">
                  <c:v>67.2</c:v>
                </c:pt>
                <c:pt idx="2">
                  <c:v>81.356000000000009</c:v>
                </c:pt>
                <c:pt idx="3">
                  <c:v>97.33599999999997</c:v>
                </c:pt>
                <c:pt idx="4">
                  <c:v>115.19999999999999</c:v>
                </c:pt>
                <c:pt idx="5">
                  <c:v>137.5</c:v>
                </c:pt>
                <c:pt idx="6">
                  <c:v>180.79200000000003</c:v>
                </c:pt>
                <c:pt idx="7">
                  <c:v>279.07499999999999</c:v>
                </c:pt>
                <c:pt idx="8">
                  <c:v>399.16800000000006</c:v>
                </c:pt>
                <c:pt idx="9">
                  <c:v>450</c:v>
                </c:pt>
                <c:pt idx="10">
                  <c:v>564.8159999999999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74DF-D948-A39A-F5088C6883B0}"/>
            </c:ext>
          </c:extLst>
        </c:ser>
        <c:ser>
          <c:idx val="6"/>
          <c:order val="6"/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val>
            <c:numRef>
              <c:f>Sheet1!$AI$112:$AP$112</c:f>
              <c:numCache>
                <c:formatCode>General</c:formatCode>
                <c:ptCount val="8"/>
                <c:pt idx="0">
                  <c:v>49.247999999999998</c:v>
                </c:pt>
                <c:pt idx="1">
                  <c:v>59.318999999999996</c:v>
                </c:pt>
                <c:pt idx="2">
                  <c:v>70.60199999999999</c:v>
                </c:pt>
                <c:pt idx="3">
                  <c:v>95.175000000000011</c:v>
                </c:pt>
                <c:pt idx="4">
                  <c:v>117.50399999999998</c:v>
                </c:pt>
                <c:pt idx="5">
                  <c:v>137.5</c:v>
                </c:pt>
                <c:pt idx="6">
                  <c:v>191.69100000000003</c:v>
                </c:pt>
                <c:pt idx="7">
                  <c:v>309.7410000000000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74DF-D948-A39A-F5088C6883B0}"/>
            </c:ext>
          </c:extLst>
        </c:ser>
        <c:ser>
          <c:idx val="7"/>
          <c:order val="7"/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val>
            <c:numRef>
              <c:f>Sheet1!$AI$113:$AP$113</c:f>
              <c:numCache>
                <c:formatCode>General</c:formatCode>
                <c:ptCount val="8"/>
                <c:pt idx="0">
                  <c:v>46.656000000000006</c:v>
                </c:pt>
                <c:pt idx="1">
                  <c:v>62.36099999999999</c:v>
                </c:pt>
                <c:pt idx="2">
                  <c:v>79.38000000000001</c:v>
                </c:pt>
                <c:pt idx="3">
                  <c:v>108.24100000000001</c:v>
                </c:pt>
                <c:pt idx="4">
                  <c:v>143.05499999999998</c:v>
                </c:pt>
                <c:pt idx="5">
                  <c:v>181.88799999999998</c:v>
                </c:pt>
                <c:pt idx="6">
                  <c:v>226.79999999999998</c:v>
                </c:pt>
                <c:pt idx="7">
                  <c:v>347.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74DF-D948-A39A-F5088C6883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17768624"/>
        <c:axId val="317761176"/>
      </c:lineChart>
      <c:catAx>
        <c:axId val="3177686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761176"/>
        <c:crosses val="autoZero"/>
        <c:auto val="1"/>
        <c:lblAlgn val="ctr"/>
        <c:lblOffset val="100"/>
        <c:noMultiLvlLbl val="0"/>
      </c:catAx>
      <c:valAx>
        <c:axId val="317761176"/>
        <c:scaling>
          <c:orientation val="minMax"/>
          <c:max val="1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Tumor size (mm</a:t>
                </a:r>
                <a:r>
                  <a:rPr lang="en-US" sz="1000" b="0" i="0" u="none" strike="noStrike" baseline="30000" dirty="0">
                    <a:effectLst/>
                  </a:rPr>
                  <a:t>3</a:t>
                </a:r>
                <a:r>
                  <a:rPr lang="en-US" b="1" dirty="0">
                    <a:solidFill>
                      <a:schemeClr val="tx1"/>
                    </a:solidFill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3.278650168950536E-3"/>
              <c:y val="4.160781180596397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768624"/>
        <c:crosses val="autoZero"/>
        <c:crossBetween val="midCat"/>
        <c:majorUnit val="2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 err="1">
                <a:solidFill>
                  <a:schemeClr val="tx1"/>
                </a:solidFill>
              </a:rPr>
              <a:t>CpGMel</a:t>
            </a:r>
            <a:endParaRPr lang="en-US" b="1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0094091727111802"/>
          <c:y val="5.412699541576656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2150389040211397"/>
          <c:y val="7.435674048260392E-2"/>
          <c:w val="0.59586888522374204"/>
          <c:h val="0.64373512791107712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cat>
            <c:numRef>
              <c:f>Sheet1!$E$127:$P$127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</c:numCache>
            </c:numRef>
          </c:cat>
          <c:val>
            <c:numRef>
              <c:f>Sheet1!$AI$129:$AP$129</c:f>
              <c:numCache>
                <c:formatCode>General</c:formatCode>
                <c:ptCount val="8"/>
                <c:pt idx="0">
                  <c:v>47.915999999999997</c:v>
                </c:pt>
                <c:pt idx="1">
                  <c:v>67.081000000000017</c:v>
                </c:pt>
                <c:pt idx="2">
                  <c:v>97.02000000000001</c:v>
                </c:pt>
                <c:pt idx="3">
                  <c:v>157.5</c:v>
                </c:pt>
                <c:pt idx="4">
                  <c:v>222.65599999999998</c:v>
                </c:pt>
                <c:pt idx="5">
                  <c:v>288</c:v>
                </c:pt>
                <c:pt idx="6">
                  <c:v>361.548</c:v>
                </c:pt>
                <c:pt idx="7">
                  <c:v>453.6899999999999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391-8944-A1AE-F3F3228D8858}"/>
            </c:ext>
          </c:extLst>
        </c:ser>
        <c:ser>
          <c:idx val="1"/>
          <c:order val="1"/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val>
            <c:numRef>
              <c:f>Sheet1!$AI$130:$AS$130</c:f>
              <c:numCache>
                <c:formatCode>General</c:formatCode>
                <c:ptCount val="11"/>
                <c:pt idx="0">
                  <c:v>64</c:v>
                </c:pt>
                <c:pt idx="1">
                  <c:v>70.400000000000006</c:v>
                </c:pt>
                <c:pt idx="2">
                  <c:v>90.992000000000019</c:v>
                </c:pt>
                <c:pt idx="3">
                  <c:v>124.85200000000003</c:v>
                </c:pt>
                <c:pt idx="4">
                  <c:v>165.73099999999999</c:v>
                </c:pt>
                <c:pt idx="5">
                  <c:v>204.68699999999998</c:v>
                </c:pt>
                <c:pt idx="6">
                  <c:v>229.74600000000001</c:v>
                </c:pt>
                <c:pt idx="7">
                  <c:v>304.91999999999996</c:v>
                </c:pt>
                <c:pt idx="8">
                  <c:v>357.0750000000000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391-8944-A1AE-F3F3228D8858}"/>
            </c:ext>
          </c:extLst>
        </c:ser>
        <c:ser>
          <c:idx val="2"/>
          <c:order val="2"/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val>
            <c:numRef>
              <c:f>Sheet1!$AI$131:$AS$131</c:f>
              <c:numCache>
                <c:formatCode>General</c:formatCode>
                <c:ptCount val="11"/>
                <c:pt idx="0">
                  <c:v>44.1</c:v>
                </c:pt>
                <c:pt idx="1">
                  <c:v>56.129000000000005</c:v>
                </c:pt>
                <c:pt idx="2">
                  <c:v>68.445000000000007</c:v>
                </c:pt>
                <c:pt idx="3">
                  <c:v>96.800000000000011</c:v>
                </c:pt>
                <c:pt idx="4">
                  <c:v>136.85700000000003</c:v>
                </c:pt>
                <c:pt idx="5">
                  <c:v>157.5</c:v>
                </c:pt>
                <c:pt idx="6">
                  <c:v>199.64999999999998</c:v>
                </c:pt>
                <c:pt idx="7">
                  <c:v>280.61200000000002</c:v>
                </c:pt>
                <c:pt idx="8">
                  <c:v>316.875</c:v>
                </c:pt>
                <c:pt idx="9">
                  <c:v>426.32</c:v>
                </c:pt>
                <c:pt idx="10">
                  <c:v>550.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E391-8944-A1AE-F3F3228D8858}"/>
            </c:ext>
          </c:extLst>
        </c:ser>
        <c:ser>
          <c:idx val="3"/>
          <c:order val="3"/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val>
            <c:numRef>
              <c:f>Sheet1!$AI$132:$AR$132</c:f>
              <c:numCache>
                <c:formatCode>General</c:formatCode>
                <c:ptCount val="10"/>
                <c:pt idx="0">
                  <c:v>45.083999999999996</c:v>
                </c:pt>
                <c:pt idx="1">
                  <c:v>66.923999999999992</c:v>
                </c:pt>
                <c:pt idx="2">
                  <c:v>96.800000000000011</c:v>
                </c:pt>
                <c:pt idx="3">
                  <c:v>127.25300000000001</c:v>
                </c:pt>
                <c:pt idx="4">
                  <c:v>162.24</c:v>
                </c:pt>
                <c:pt idx="5">
                  <c:v>185.39399999999998</c:v>
                </c:pt>
                <c:pt idx="6">
                  <c:v>212.86800000000002</c:v>
                </c:pt>
                <c:pt idx="7">
                  <c:v>305.613</c:v>
                </c:pt>
                <c:pt idx="8">
                  <c:v>356.048</c:v>
                </c:pt>
                <c:pt idx="9">
                  <c:v>444.37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E391-8944-A1AE-F3F3228D8858}"/>
            </c:ext>
          </c:extLst>
        </c:ser>
        <c:ser>
          <c:idx val="4"/>
          <c:order val="4"/>
          <c:tx>
            <c:strRef>
              <c:f>Sheet1!$E$132:$M$132</c:f>
              <c:strCache>
                <c:ptCount val="9"/>
                <c:pt idx="0">
                  <c:v>25.92</c:v>
                </c:pt>
                <c:pt idx="1">
                  <c:v>30.324</c:v>
                </c:pt>
                <c:pt idx="2">
                  <c:v>45.3005</c:v>
                </c:pt>
                <c:pt idx="3">
                  <c:v>63.36</c:v>
                </c:pt>
                <c:pt idx="4">
                  <c:v>79.768</c:v>
                </c:pt>
                <c:pt idx="5">
                  <c:v>100.719</c:v>
                </c:pt>
                <c:pt idx="6">
                  <c:v>120.9325</c:v>
                </c:pt>
                <c:pt idx="7">
                  <c:v>140.8995</c:v>
                </c:pt>
                <c:pt idx="8">
                  <c:v>190.44</c:v>
                </c:pt>
              </c:strCache>
            </c:strRef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val>
            <c:numRef>
              <c:f>Sheet1!$AI$133:$AQ$133</c:f>
              <c:numCache>
                <c:formatCode>General</c:formatCode>
                <c:ptCount val="9"/>
                <c:pt idx="0">
                  <c:v>51.84</c:v>
                </c:pt>
                <c:pt idx="1">
                  <c:v>60.647999999999996</c:v>
                </c:pt>
                <c:pt idx="2">
                  <c:v>90.600999999999999</c:v>
                </c:pt>
                <c:pt idx="3">
                  <c:v>126.71999999999998</c:v>
                </c:pt>
                <c:pt idx="4">
                  <c:v>159.53600000000003</c:v>
                </c:pt>
                <c:pt idx="5">
                  <c:v>201.43800000000002</c:v>
                </c:pt>
                <c:pt idx="6">
                  <c:v>241.86499999999998</c:v>
                </c:pt>
                <c:pt idx="7">
                  <c:v>281.79899999999998</c:v>
                </c:pt>
                <c:pt idx="8">
                  <c:v>377.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E391-8944-A1AE-F3F3228D8858}"/>
            </c:ext>
          </c:extLst>
        </c:ser>
        <c:ser>
          <c:idx val="5"/>
          <c:order val="5"/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val>
            <c:numRef>
              <c:f>Sheet1!$AI$134:$AP$134</c:f>
              <c:numCache>
                <c:formatCode>General</c:formatCode>
                <c:ptCount val="8"/>
                <c:pt idx="0">
                  <c:v>59.203999999999994</c:v>
                </c:pt>
                <c:pt idx="1">
                  <c:v>70.400000000000006</c:v>
                </c:pt>
                <c:pt idx="2">
                  <c:v>106.032</c:v>
                </c:pt>
                <c:pt idx="3">
                  <c:v>130</c:v>
                </c:pt>
                <c:pt idx="4">
                  <c:v>157.30399999999997</c:v>
                </c:pt>
                <c:pt idx="5">
                  <c:v>194.94000000000003</c:v>
                </c:pt>
                <c:pt idx="6">
                  <c:v>214.434</c:v>
                </c:pt>
                <c:pt idx="7">
                  <c:v>308.4249999999999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E391-8944-A1AE-F3F3228D8858}"/>
            </c:ext>
          </c:extLst>
        </c:ser>
        <c:ser>
          <c:idx val="6"/>
          <c:order val="6"/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val>
            <c:numRef>
              <c:f>Sheet1!$AI$135:$AS$135</c:f>
              <c:numCache>
                <c:formatCode>General</c:formatCode>
                <c:ptCount val="11"/>
                <c:pt idx="0">
                  <c:v>43.927999999999997</c:v>
                </c:pt>
                <c:pt idx="1">
                  <c:v>51.45</c:v>
                </c:pt>
                <c:pt idx="2">
                  <c:v>84.8</c:v>
                </c:pt>
                <c:pt idx="3">
                  <c:v>144.06000000000003</c:v>
                </c:pt>
                <c:pt idx="4">
                  <c:v>202.67500000000001</c:v>
                </c:pt>
                <c:pt idx="5">
                  <c:v>261.07499999999999</c:v>
                </c:pt>
                <c:pt idx="6">
                  <c:v>317.52</c:v>
                </c:pt>
                <c:pt idx="7">
                  <c:v>411.53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E391-8944-A1AE-F3F3228D8858}"/>
            </c:ext>
          </c:extLst>
        </c:ser>
        <c:ser>
          <c:idx val="7"/>
          <c:order val="7"/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val>
            <c:numRef>
              <c:f>Sheet1!$AI$136:$AP$136</c:f>
              <c:numCache>
                <c:formatCode>General</c:formatCode>
                <c:ptCount val="8"/>
                <c:pt idx="0">
                  <c:v>59.318999999999996</c:v>
                </c:pt>
                <c:pt idx="1">
                  <c:v>63.881999999999998</c:v>
                </c:pt>
                <c:pt idx="2">
                  <c:v>85.184000000000026</c:v>
                </c:pt>
                <c:pt idx="3">
                  <c:v>117.50399999999998</c:v>
                </c:pt>
                <c:pt idx="4">
                  <c:v>154.49499999999998</c:v>
                </c:pt>
                <c:pt idx="5">
                  <c:v>205.37900000000002</c:v>
                </c:pt>
                <c:pt idx="6">
                  <c:v>226.79999999999998</c:v>
                </c:pt>
                <c:pt idx="7">
                  <c:v>287.4959999999999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E391-8944-A1AE-F3F3228D88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17762352"/>
        <c:axId val="317762744"/>
      </c:lineChart>
      <c:catAx>
        <c:axId val="3177623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762744"/>
        <c:crosses val="autoZero"/>
        <c:auto val="1"/>
        <c:lblAlgn val="ctr"/>
        <c:lblOffset val="100"/>
        <c:noMultiLvlLbl val="0"/>
      </c:catAx>
      <c:valAx>
        <c:axId val="317762744"/>
        <c:scaling>
          <c:orientation val="minMax"/>
          <c:max val="1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1" i="0" baseline="0" dirty="0">
                    <a:solidFill>
                      <a:schemeClr val="tx1"/>
                    </a:solidFill>
                    <a:effectLst/>
                  </a:rPr>
                  <a:t>Tumor size (mm</a:t>
                </a:r>
                <a:r>
                  <a:rPr lang="en-US" sz="900" b="1" i="0" u="none" strike="noStrike" baseline="30000" dirty="0">
                    <a:effectLst/>
                  </a:rPr>
                  <a:t>3</a:t>
                </a:r>
                <a:r>
                  <a:rPr lang="en-US" sz="900" b="1" i="0" baseline="0" dirty="0">
                    <a:solidFill>
                      <a:schemeClr val="tx1"/>
                    </a:solidFill>
                    <a:effectLst/>
                  </a:rPr>
                  <a:t>)</a:t>
                </a:r>
                <a:endParaRPr lang="en-US" sz="900" b="1" dirty="0">
                  <a:solidFill>
                    <a:schemeClr val="tx1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7.8245477627030303E-3"/>
              <c:y val="8.37652350938330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7762352"/>
        <c:crosses val="autoZero"/>
        <c:crossBetween val="midCat"/>
        <c:majorUnit val="2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b="1" i="0" baseline="0" dirty="0">
                <a:solidFill>
                  <a:schemeClr val="tx1"/>
                </a:solidFill>
                <a:effectLst/>
              </a:rPr>
              <a:t>miR-CVB3+CpGMel </a:t>
            </a:r>
            <a:endParaRPr lang="en-US" sz="1200" dirty="0">
              <a:solidFill>
                <a:schemeClr val="tx1"/>
              </a:solidFill>
              <a:effectLst/>
            </a:endParaRPr>
          </a:p>
        </c:rich>
      </c:tx>
      <c:layout>
        <c:manualLayout>
          <c:xMode val="edge"/>
          <c:yMode val="edge"/>
          <c:x val="0.33743836733449678"/>
          <c:y val="5.32030394156323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6497769826254131"/>
          <c:y val="6.7833875254931217E-2"/>
          <c:w val="0.66331092680343029"/>
          <c:h val="0.64665850700541594"/>
        </c:manualLayout>
      </c:layout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AI$234:$AV$234</c:f>
              <c:numCache>
                <c:formatCode>General</c:formatCode>
                <c:ptCount val="1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40</c:v>
                </c:pt>
              </c:numCache>
            </c:numRef>
          </c:xVal>
          <c:yVal>
            <c:numRef>
              <c:f>Sheet1!$AI$235:$AV$235</c:f>
              <c:numCache>
                <c:formatCode>General</c:formatCode>
                <c:ptCount val="14"/>
                <c:pt idx="0">
                  <c:v>50.224999999999994</c:v>
                </c:pt>
                <c:pt idx="1">
                  <c:v>55.728000000000002</c:v>
                </c:pt>
                <c:pt idx="2">
                  <c:v>60.236000000000004</c:v>
                </c:pt>
                <c:pt idx="3">
                  <c:v>58.867000000000004</c:v>
                </c:pt>
                <c:pt idx="4">
                  <c:v>63.535999999999994</c:v>
                </c:pt>
                <c:pt idx="5">
                  <c:v>73.599999999999994</c:v>
                </c:pt>
                <c:pt idx="6">
                  <c:v>86.436000000000007</c:v>
                </c:pt>
                <c:pt idx="7">
                  <c:v>100.67200000000003</c:v>
                </c:pt>
                <c:pt idx="8">
                  <c:v>102.608</c:v>
                </c:pt>
                <c:pt idx="9">
                  <c:v>111.375</c:v>
                </c:pt>
                <c:pt idx="10">
                  <c:v>120.61199999999998</c:v>
                </c:pt>
                <c:pt idx="11">
                  <c:v>131.328</c:v>
                </c:pt>
                <c:pt idx="12">
                  <c:v>141.65900000000002</c:v>
                </c:pt>
                <c:pt idx="13">
                  <c:v>146.4610000000000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A962-AC4D-AC49-68D7E93ABFA4}"/>
            </c:ext>
          </c:extLst>
        </c:ser>
        <c:ser>
          <c:idx val="1"/>
          <c:order val="1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AI$234:$AV$234</c:f>
              <c:numCache>
                <c:formatCode>General</c:formatCode>
                <c:ptCount val="1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40</c:v>
                </c:pt>
              </c:numCache>
            </c:numRef>
          </c:xVal>
          <c:yVal>
            <c:numRef>
              <c:f>Sheet1!$AI$236:$AV$236</c:f>
              <c:numCache>
                <c:formatCode>General</c:formatCode>
                <c:ptCount val="14"/>
                <c:pt idx="0">
                  <c:v>60.647999999999996</c:v>
                </c:pt>
                <c:pt idx="1">
                  <c:v>68.8</c:v>
                </c:pt>
                <c:pt idx="2">
                  <c:v>72</c:v>
                </c:pt>
                <c:pt idx="3">
                  <c:v>70.400000000000006</c:v>
                </c:pt>
                <c:pt idx="4">
                  <c:v>82.908000000000015</c:v>
                </c:pt>
                <c:pt idx="5">
                  <c:v>86.903000000000006</c:v>
                </c:pt>
                <c:pt idx="6">
                  <c:v>96.800000000000011</c:v>
                </c:pt>
                <c:pt idx="7">
                  <c:v>109.35000000000001</c:v>
                </c:pt>
                <c:pt idx="8">
                  <c:v>99.845999999999989</c:v>
                </c:pt>
                <c:pt idx="9">
                  <c:v>111.375</c:v>
                </c:pt>
                <c:pt idx="10">
                  <c:v>106.48000000000002</c:v>
                </c:pt>
                <c:pt idx="11">
                  <c:v>113.39999999999999</c:v>
                </c:pt>
                <c:pt idx="12">
                  <c:v>132.54000000000002</c:v>
                </c:pt>
                <c:pt idx="13">
                  <c:v>15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A962-AC4D-AC49-68D7E93ABFA4}"/>
            </c:ext>
          </c:extLst>
        </c:ser>
        <c:ser>
          <c:idx val="2"/>
          <c:order val="2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AI$234:$AV$234</c:f>
              <c:numCache>
                <c:formatCode>General</c:formatCode>
                <c:ptCount val="1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40</c:v>
                </c:pt>
              </c:numCache>
            </c:numRef>
          </c:xVal>
          <c:yVal>
            <c:numRef>
              <c:f>Sheet1!$AI$237:$AV$237</c:f>
              <c:numCache>
                <c:formatCode>General</c:formatCode>
                <c:ptCount val="14"/>
                <c:pt idx="0">
                  <c:v>55.125</c:v>
                </c:pt>
                <c:pt idx="1">
                  <c:v>55.125</c:v>
                </c:pt>
                <c:pt idx="2">
                  <c:v>67.081000000000017</c:v>
                </c:pt>
                <c:pt idx="3">
                  <c:v>72.2</c:v>
                </c:pt>
                <c:pt idx="4">
                  <c:v>74.528999999999996</c:v>
                </c:pt>
                <c:pt idx="5">
                  <c:v>80</c:v>
                </c:pt>
                <c:pt idx="6">
                  <c:v>103.27499999999999</c:v>
                </c:pt>
                <c:pt idx="7">
                  <c:v>135.25199999999998</c:v>
                </c:pt>
                <c:pt idx="8">
                  <c:v>154.49499999999998</c:v>
                </c:pt>
                <c:pt idx="9">
                  <c:v>163.35000000000002</c:v>
                </c:pt>
                <c:pt idx="10">
                  <c:v>188.44200000000001</c:v>
                </c:pt>
                <c:pt idx="11">
                  <c:v>219.59999999999997</c:v>
                </c:pt>
                <c:pt idx="12">
                  <c:v>250.04699999999997</c:v>
                </c:pt>
                <c:pt idx="13">
                  <c:v>266.2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A962-AC4D-AC49-68D7E93ABFA4}"/>
            </c:ext>
          </c:extLst>
        </c:ser>
        <c:ser>
          <c:idx val="3"/>
          <c:order val="3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AI$234:$AV$234</c:f>
              <c:numCache>
                <c:formatCode>General</c:formatCode>
                <c:ptCount val="1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40</c:v>
                </c:pt>
              </c:numCache>
            </c:numRef>
          </c:xVal>
          <c:yVal>
            <c:numRef>
              <c:f>Sheet1!$AI$238:$AV$238</c:f>
              <c:numCache>
                <c:formatCode>General</c:formatCode>
                <c:ptCount val="14"/>
                <c:pt idx="0">
                  <c:v>73.007999999999996</c:v>
                </c:pt>
                <c:pt idx="1">
                  <c:v>84.05</c:v>
                </c:pt>
                <c:pt idx="2">
                  <c:v>88.2</c:v>
                </c:pt>
                <c:pt idx="3">
                  <c:v>92.928000000000011</c:v>
                </c:pt>
                <c:pt idx="4">
                  <c:v>92.928000000000011</c:v>
                </c:pt>
                <c:pt idx="5">
                  <c:v>96.800000000000011</c:v>
                </c:pt>
                <c:pt idx="6">
                  <c:v>110.45</c:v>
                </c:pt>
                <c:pt idx="7">
                  <c:v>144.06000000000003</c:v>
                </c:pt>
                <c:pt idx="8">
                  <c:v>150</c:v>
                </c:pt>
                <c:pt idx="9">
                  <c:v>150</c:v>
                </c:pt>
                <c:pt idx="10">
                  <c:v>176.96699999999998</c:v>
                </c:pt>
                <c:pt idx="11">
                  <c:v>189.54000000000002</c:v>
                </c:pt>
                <c:pt idx="12">
                  <c:v>203.83999999999997</c:v>
                </c:pt>
                <c:pt idx="13">
                  <c:v>220.9319999999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A962-AC4D-AC49-68D7E93ABFA4}"/>
            </c:ext>
          </c:extLst>
        </c:ser>
        <c:ser>
          <c:idx val="4"/>
          <c:order val="4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AI$234:$AV$234</c:f>
              <c:numCache>
                <c:formatCode>General</c:formatCode>
                <c:ptCount val="1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40</c:v>
                </c:pt>
              </c:numCache>
            </c:numRef>
          </c:xVal>
          <c:yVal>
            <c:numRef>
              <c:f>Sheet1!$AI$239:$AV$239</c:f>
              <c:numCache>
                <c:formatCode>General</c:formatCode>
                <c:ptCount val="14"/>
                <c:pt idx="0">
                  <c:v>51.45</c:v>
                </c:pt>
                <c:pt idx="1">
                  <c:v>55.125</c:v>
                </c:pt>
                <c:pt idx="2">
                  <c:v>45.056000000000012</c:v>
                </c:pt>
                <c:pt idx="3">
                  <c:v>43.245000000000005</c:v>
                </c:pt>
                <c:pt idx="4">
                  <c:v>52.019999999999996</c:v>
                </c:pt>
                <c:pt idx="5">
                  <c:v>68.45</c:v>
                </c:pt>
                <c:pt idx="6">
                  <c:v>88</c:v>
                </c:pt>
                <c:pt idx="7">
                  <c:v>126.95999999999998</c:v>
                </c:pt>
                <c:pt idx="8">
                  <c:v>122.72799999999997</c:v>
                </c:pt>
                <c:pt idx="9">
                  <c:v>128.12200000000001</c:v>
                </c:pt>
                <c:pt idx="10">
                  <c:v>135.93600000000001</c:v>
                </c:pt>
                <c:pt idx="11">
                  <c:v>160</c:v>
                </c:pt>
                <c:pt idx="12">
                  <c:v>185.39399999999998</c:v>
                </c:pt>
                <c:pt idx="13">
                  <c:v>206.9759999999999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A962-AC4D-AC49-68D7E93ABFA4}"/>
            </c:ext>
          </c:extLst>
        </c:ser>
        <c:ser>
          <c:idx val="5"/>
          <c:order val="5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AI$234:$AV$234</c:f>
              <c:numCache>
                <c:formatCode>General</c:formatCode>
                <c:ptCount val="1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40</c:v>
                </c:pt>
              </c:numCache>
            </c:numRef>
          </c:xVal>
          <c:yVal>
            <c:numRef>
              <c:f>Sheet1!$AI$240:$AV$240</c:f>
              <c:numCache>
                <c:formatCode>General</c:formatCode>
                <c:ptCount val="14"/>
                <c:pt idx="0">
                  <c:v>47.952000000000005</c:v>
                </c:pt>
                <c:pt idx="1">
                  <c:v>50.653000000000006</c:v>
                </c:pt>
                <c:pt idx="2">
                  <c:v>50.653000000000006</c:v>
                </c:pt>
                <c:pt idx="3">
                  <c:v>50.653000000000006</c:v>
                </c:pt>
                <c:pt idx="4">
                  <c:v>44.1</c:v>
                </c:pt>
                <c:pt idx="5">
                  <c:v>51.84</c:v>
                </c:pt>
                <c:pt idx="6">
                  <c:v>69.965999999999994</c:v>
                </c:pt>
                <c:pt idx="7">
                  <c:v>88.751999999999981</c:v>
                </c:pt>
                <c:pt idx="8">
                  <c:v>88.751999999999981</c:v>
                </c:pt>
                <c:pt idx="9">
                  <c:v>101.25</c:v>
                </c:pt>
                <c:pt idx="10">
                  <c:v>111.375</c:v>
                </c:pt>
                <c:pt idx="11">
                  <c:v>116.37999999999998</c:v>
                </c:pt>
                <c:pt idx="12">
                  <c:v>128.12200000000001</c:v>
                </c:pt>
                <c:pt idx="13">
                  <c:v>150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5-A962-AC4D-AC49-68D7E93ABFA4}"/>
            </c:ext>
          </c:extLst>
        </c:ser>
        <c:ser>
          <c:idx val="6"/>
          <c:order val="6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AI$234:$AV$234</c:f>
              <c:numCache>
                <c:formatCode>General</c:formatCode>
                <c:ptCount val="1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40</c:v>
                </c:pt>
              </c:numCache>
            </c:numRef>
          </c:xVal>
          <c:yVal>
            <c:numRef>
              <c:f>Sheet1!$AI$241:$AV$241</c:f>
              <c:numCache>
                <c:formatCode>General</c:formatCode>
                <c:ptCount val="14"/>
                <c:pt idx="0">
                  <c:v>50.653000000000006</c:v>
                </c:pt>
                <c:pt idx="1">
                  <c:v>59.318999999999996</c:v>
                </c:pt>
                <c:pt idx="2">
                  <c:v>60.647999999999996</c:v>
                </c:pt>
                <c:pt idx="3">
                  <c:v>64</c:v>
                </c:pt>
                <c:pt idx="4">
                  <c:v>56.129000000000005</c:v>
                </c:pt>
                <c:pt idx="5">
                  <c:v>62.091999999999999</c:v>
                </c:pt>
                <c:pt idx="6">
                  <c:v>68.8</c:v>
                </c:pt>
                <c:pt idx="7">
                  <c:v>92.45</c:v>
                </c:pt>
                <c:pt idx="8">
                  <c:v>88.2</c:v>
                </c:pt>
                <c:pt idx="9">
                  <c:v>98.736000000000018</c:v>
                </c:pt>
                <c:pt idx="10">
                  <c:v>98.736000000000018</c:v>
                </c:pt>
                <c:pt idx="11">
                  <c:v>98.736000000000018</c:v>
                </c:pt>
                <c:pt idx="12">
                  <c:v>117.077</c:v>
                </c:pt>
                <c:pt idx="13">
                  <c:v>131.32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6-A962-AC4D-AC49-68D7E93ABFA4}"/>
            </c:ext>
          </c:extLst>
        </c:ser>
        <c:ser>
          <c:idx val="7"/>
          <c:order val="7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AI$234:$AV$234</c:f>
              <c:numCache>
                <c:formatCode>General</c:formatCode>
                <c:ptCount val="1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40</c:v>
                </c:pt>
              </c:numCache>
            </c:numRef>
          </c:xVal>
          <c:yVal>
            <c:numRef>
              <c:f>Sheet1!$AI$242:$AV$242</c:f>
              <c:numCache>
                <c:formatCode>General</c:formatCode>
                <c:ptCount val="14"/>
                <c:pt idx="0">
                  <c:v>68.8</c:v>
                </c:pt>
                <c:pt idx="1">
                  <c:v>85.053999999999988</c:v>
                </c:pt>
                <c:pt idx="2">
                  <c:v>99.225000000000009</c:v>
                </c:pt>
                <c:pt idx="3">
                  <c:v>89.055999999999997</c:v>
                </c:pt>
                <c:pt idx="4">
                  <c:v>99.225000000000009</c:v>
                </c:pt>
                <c:pt idx="5">
                  <c:v>119.80799999999999</c:v>
                </c:pt>
                <c:pt idx="6">
                  <c:v>145.65599999999998</c:v>
                </c:pt>
                <c:pt idx="7">
                  <c:v>168.54</c:v>
                </c:pt>
                <c:pt idx="8">
                  <c:v>186.62400000000002</c:v>
                </c:pt>
                <c:pt idx="9">
                  <c:v>186.62400000000002</c:v>
                </c:pt>
                <c:pt idx="10">
                  <c:v>199.64999999999998</c:v>
                </c:pt>
                <c:pt idx="11">
                  <c:v>220.93199999999999</c:v>
                </c:pt>
                <c:pt idx="12">
                  <c:v>264.19099999999997</c:v>
                </c:pt>
                <c:pt idx="13">
                  <c:v>311.2960000000000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7-A962-AC4D-AC49-68D7E93ABF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9014256"/>
        <c:axId val="299013080"/>
      </c:scatterChart>
      <c:valAx>
        <c:axId val="299014256"/>
        <c:scaling>
          <c:orientation val="minMax"/>
          <c:max val="4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>
                    <a:solidFill>
                      <a:schemeClr val="tx1"/>
                    </a:solidFill>
                  </a:rPr>
                  <a:t>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9013080"/>
        <c:crosses val="autoZero"/>
        <c:crossBetween val="midCat"/>
        <c:majorUnit val="6"/>
      </c:valAx>
      <c:valAx>
        <c:axId val="299013080"/>
        <c:scaling>
          <c:orientation val="minMax"/>
          <c:max val="1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>
                    <a:solidFill>
                      <a:schemeClr val="tx1"/>
                    </a:solidFill>
                  </a:rPr>
                  <a:t>Tumor size (mm</a:t>
                </a:r>
                <a:r>
                  <a:rPr lang="en-US" sz="1000" b="1" i="0" u="none" strike="noStrike" baseline="30000" dirty="0">
                    <a:effectLst/>
                  </a:rPr>
                  <a:t>3</a:t>
                </a:r>
                <a:r>
                  <a:rPr lang="en-US" dirty="0">
                    <a:solidFill>
                      <a:schemeClr val="tx1"/>
                    </a:solidFill>
                  </a:rPr>
                  <a:t>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9014256"/>
        <c:crosses val="autoZero"/>
        <c:crossBetween val="midCat"/>
        <c:majorUnit val="2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820171166458081"/>
          <c:y val="7.8703703703703706E-2"/>
          <c:w val="0.72132557178325851"/>
          <c:h val="0.5948735053951589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0070C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5D8-9D43-BFEC-D2C0DAFC8A15}"/>
              </c:ext>
            </c:extLst>
          </c:dPt>
          <c:dPt>
            <c:idx val="2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5D8-9D43-BFEC-D2C0DAFC8A15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5D8-9D43-BFEC-D2C0DAFC8A15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K$29:$N$29</c:f>
                <c:numCache>
                  <c:formatCode>General</c:formatCode>
                  <c:ptCount val="4"/>
                  <c:pt idx="0">
                    <c:v>1E-3</c:v>
                  </c:pt>
                  <c:pt idx="1">
                    <c:v>8.8000000000000007</c:v>
                  </c:pt>
                  <c:pt idx="2">
                    <c:v>4.03</c:v>
                  </c:pt>
                  <c:pt idx="3">
                    <c:v>3.7</c:v>
                  </c:pt>
                </c:numCache>
              </c:numRef>
            </c:plus>
            <c:minus>
              <c:numRef>
                <c:f>Sheet2!$K$29:$N$29</c:f>
                <c:numCache>
                  <c:formatCode>General</c:formatCode>
                  <c:ptCount val="4"/>
                  <c:pt idx="0">
                    <c:v>1E-3</c:v>
                  </c:pt>
                  <c:pt idx="1">
                    <c:v>8.8000000000000007</c:v>
                  </c:pt>
                  <c:pt idx="2">
                    <c:v>4.03</c:v>
                  </c:pt>
                  <c:pt idx="3">
                    <c:v>3.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K$27:$N$27</c:f>
              <c:strCache>
                <c:ptCount val="4"/>
                <c:pt idx="0">
                  <c:v>Sham</c:v>
                </c:pt>
                <c:pt idx="1">
                  <c:v>CpGMel</c:v>
                </c:pt>
                <c:pt idx="2">
                  <c:v>miR-CVB3</c:v>
                </c:pt>
                <c:pt idx="3">
                  <c:v>miR-CVB3+CpGMel</c:v>
                </c:pt>
              </c:strCache>
            </c:strRef>
          </c:cat>
          <c:val>
            <c:numRef>
              <c:f>Sheet2!$K$28:$N$28</c:f>
              <c:numCache>
                <c:formatCode>General</c:formatCode>
                <c:ptCount val="4"/>
                <c:pt idx="0">
                  <c:v>1E-3</c:v>
                </c:pt>
                <c:pt idx="1">
                  <c:v>55.85</c:v>
                </c:pt>
                <c:pt idx="2">
                  <c:v>59.34</c:v>
                </c:pt>
                <c:pt idx="3">
                  <c:v>83.8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E5D8-9D43-BFEC-D2C0DAFC8A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011120"/>
        <c:axId val="299011512"/>
      </c:barChart>
      <c:catAx>
        <c:axId val="299011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9011512"/>
        <c:crosses val="autoZero"/>
        <c:auto val="1"/>
        <c:lblAlgn val="ctr"/>
        <c:lblOffset val="100"/>
        <c:noMultiLvlLbl val="0"/>
      </c:catAx>
      <c:valAx>
        <c:axId val="2990115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rgbClr val="FF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>
                    <a:solidFill>
                      <a:schemeClr val="tx1"/>
                    </a:solidFill>
                  </a:rPr>
                  <a:t>Tumor</a:t>
                </a:r>
                <a:r>
                  <a:rPr lang="en-US" baseline="0" dirty="0">
                    <a:solidFill>
                      <a:schemeClr val="tx1"/>
                    </a:solidFill>
                  </a:rPr>
                  <a:t> suppression rate</a:t>
                </a:r>
                <a:r>
                  <a:rPr lang="en-US" dirty="0">
                    <a:solidFill>
                      <a:schemeClr val="tx1"/>
                    </a:solidFill>
                  </a:rPr>
                  <a:t> %</a:t>
                </a:r>
              </a:p>
            </c:rich>
          </c:tx>
          <c:layout>
            <c:manualLayout>
              <c:xMode val="edge"/>
              <c:yMode val="edge"/>
              <c:x val="4.034385034929866E-2"/>
              <c:y val="0.101013050452026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rgbClr val="FF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90111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42315512584493"/>
          <c:y val="6.8595514884033093E-2"/>
          <c:w val="0.78770978086944954"/>
          <c:h val="0.76089915130482511"/>
        </c:manualLayout>
      </c:layout>
      <c:lineChart>
        <c:grouping val="standard"/>
        <c:varyColors val="0"/>
        <c:ser>
          <c:idx val="0"/>
          <c:order val="0"/>
          <c:tx>
            <c:v>Sham</c:v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[mir-tumor-chart.xlsx]Sheet1'!$O$213:$V$213</c:f>
                <c:numCache>
                  <c:formatCode>General</c:formatCode>
                  <c:ptCount val="8"/>
                  <c:pt idx="0">
                    <c:v>1.243770190073024</c:v>
                  </c:pt>
                  <c:pt idx="1">
                    <c:v>1.4004463574160912</c:v>
                  </c:pt>
                  <c:pt idx="2">
                    <c:v>1.360606482418778</c:v>
                  </c:pt>
                  <c:pt idx="3">
                    <c:v>1.3201731488169051</c:v>
                  </c:pt>
                  <c:pt idx="4">
                    <c:v>1.2769942387161679</c:v>
                  </c:pt>
                  <c:pt idx="5">
                    <c:v>1.2895181824453439</c:v>
                  </c:pt>
                  <c:pt idx="6">
                    <c:v>1.253281407232345</c:v>
                  </c:pt>
                  <c:pt idx="7">
                    <c:v>1.2739141034061687</c:v>
                  </c:pt>
                </c:numCache>
              </c:numRef>
            </c:plus>
            <c:minus>
              <c:numRef>
                <c:f>'[mir-tumor-chart.xlsx]Sheet1'!$O$213:$V$213</c:f>
                <c:numCache>
                  <c:formatCode>General</c:formatCode>
                  <c:ptCount val="8"/>
                  <c:pt idx="0">
                    <c:v>1.243770190073024</c:v>
                  </c:pt>
                  <c:pt idx="1">
                    <c:v>1.4004463574160912</c:v>
                  </c:pt>
                  <c:pt idx="2">
                    <c:v>1.360606482418778</c:v>
                  </c:pt>
                  <c:pt idx="3">
                    <c:v>1.3201731488169051</c:v>
                  </c:pt>
                  <c:pt idx="4">
                    <c:v>1.2769942387161679</c:v>
                  </c:pt>
                  <c:pt idx="5">
                    <c:v>1.2895181824453439</c:v>
                  </c:pt>
                  <c:pt idx="6">
                    <c:v>1.253281407232345</c:v>
                  </c:pt>
                  <c:pt idx="7">
                    <c:v>1.27391410340616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mir-tumor-chart.xlsx]Sheet1'!$F$212:$M$212</c:f>
              <c:numCache>
                <c:formatCode>General</c:formatCode>
                <c:ptCount val="8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</c:numCache>
            </c:numRef>
          </c:cat>
          <c:val>
            <c:numRef>
              <c:f>'[mir-tumor-chart.xlsx]Sheet1'!$F$213:$M$213</c:f>
              <c:numCache>
                <c:formatCode>General</c:formatCode>
                <c:ptCount val="8"/>
                <c:pt idx="0">
                  <c:v>19.787500000000001</c:v>
                </c:pt>
                <c:pt idx="1">
                  <c:v>19.912500000000001</c:v>
                </c:pt>
                <c:pt idx="2">
                  <c:v>19.9375</c:v>
                </c:pt>
                <c:pt idx="3">
                  <c:v>20</c:v>
                </c:pt>
                <c:pt idx="4">
                  <c:v>20.074999999999999</c:v>
                </c:pt>
                <c:pt idx="5">
                  <c:v>20.150000000000002</c:v>
                </c:pt>
                <c:pt idx="6">
                  <c:v>20.224999999999998</c:v>
                </c:pt>
                <c:pt idx="7">
                  <c:v>20.34285714285714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DED-A34A-B187-E6EF68BCAC1E}"/>
            </c:ext>
          </c:extLst>
        </c:ser>
        <c:ser>
          <c:idx val="1"/>
          <c:order val="1"/>
          <c:tx>
            <c:v>CpGMel</c:v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[mir-tumor-chart.xlsx]Sheet1'!$O$214:$V$214</c:f>
                <c:numCache>
                  <c:formatCode>General</c:formatCode>
                  <c:ptCount val="8"/>
                  <c:pt idx="0">
                    <c:v>1.5692923792042612</c:v>
                  </c:pt>
                  <c:pt idx="1">
                    <c:v>1.5955294687702524</c:v>
                  </c:pt>
                  <c:pt idx="2">
                    <c:v>1.6201851746019651</c:v>
                  </c:pt>
                  <c:pt idx="3">
                    <c:v>1.5099668870541501</c:v>
                  </c:pt>
                  <c:pt idx="4">
                    <c:v>1.5541993804804179</c:v>
                  </c:pt>
                  <c:pt idx="5">
                    <c:v>1.4918827989203061</c:v>
                  </c:pt>
                  <c:pt idx="6">
                    <c:v>1.6446884203398524</c:v>
                  </c:pt>
                  <c:pt idx="7">
                    <c:v>1.5629642167551829</c:v>
                  </c:pt>
                </c:numCache>
              </c:numRef>
            </c:plus>
            <c:minus>
              <c:numRef>
                <c:f>'[mir-tumor-chart.xlsx]Sheet1'!$O$214:$V$214</c:f>
                <c:numCache>
                  <c:formatCode>General</c:formatCode>
                  <c:ptCount val="8"/>
                  <c:pt idx="0">
                    <c:v>1.5692923792042612</c:v>
                  </c:pt>
                  <c:pt idx="1">
                    <c:v>1.5955294687702524</c:v>
                  </c:pt>
                  <c:pt idx="2">
                    <c:v>1.6201851746019651</c:v>
                  </c:pt>
                  <c:pt idx="3">
                    <c:v>1.5099668870541501</c:v>
                  </c:pt>
                  <c:pt idx="4">
                    <c:v>1.5541993804804179</c:v>
                  </c:pt>
                  <c:pt idx="5">
                    <c:v>1.4918827989203061</c:v>
                  </c:pt>
                  <c:pt idx="6">
                    <c:v>1.6446884203398524</c:v>
                  </c:pt>
                  <c:pt idx="7">
                    <c:v>1.56296421675518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mir-tumor-chart.xlsx]Sheet1'!$F$214:$M$214</c:f>
              <c:numCache>
                <c:formatCode>General</c:formatCode>
                <c:ptCount val="8"/>
                <c:pt idx="0">
                  <c:v>19.0625</c:v>
                </c:pt>
                <c:pt idx="1">
                  <c:v>19.25</c:v>
                </c:pt>
                <c:pt idx="2">
                  <c:v>19.274999999999999</c:v>
                </c:pt>
                <c:pt idx="3">
                  <c:v>19.399999999999999</c:v>
                </c:pt>
                <c:pt idx="4">
                  <c:v>19.512500000000003</c:v>
                </c:pt>
                <c:pt idx="5">
                  <c:v>19.549999999999997</c:v>
                </c:pt>
                <c:pt idx="6">
                  <c:v>19.575000000000003</c:v>
                </c:pt>
                <c:pt idx="7">
                  <c:v>19.65000000000000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9DED-A34A-B187-E6EF68BCAC1E}"/>
            </c:ext>
          </c:extLst>
        </c:ser>
        <c:ser>
          <c:idx val="2"/>
          <c:order val="2"/>
          <c:tx>
            <c:v>miR-CVB3</c:v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[mir-tumor-chart.xlsx]Sheet1'!$O$215:$V$215</c:f>
                <c:numCache>
                  <c:formatCode>General</c:formatCode>
                  <c:ptCount val="8"/>
                  <c:pt idx="0">
                    <c:v>1.397893823885471</c:v>
                  </c:pt>
                  <c:pt idx="1">
                    <c:v>1.3621804998918883</c:v>
                  </c:pt>
                  <c:pt idx="2">
                    <c:v>1.4623244705409455</c:v>
                  </c:pt>
                  <c:pt idx="3">
                    <c:v>1.244918241721692</c:v>
                  </c:pt>
                  <c:pt idx="4">
                    <c:v>1.330883165420617</c:v>
                  </c:pt>
                  <c:pt idx="5">
                    <c:v>1.449876842060337</c:v>
                  </c:pt>
                  <c:pt idx="6">
                    <c:v>1.4593907730869853</c:v>
                  </c:pt>
                  <c:pt idx="7">
                    <c:v>1.3915561689808178</c:v>
                  </c:pt>
                </c:numCache>
              </c:numRef>
            </c:plus>
            <c:minus>
              <c:numRef>
                <c:f>'[mir-tumor-chart.xlsx]Sheet1'!$O$215:$V$215</c:f>
                <c:numCache>
                  <c:formatCode>General</c:formatCode>
                  <c:ptCount val="8"/>
                  <c:pt idx="0">
                    <c:v>1.397893823885471</c:v>
                  </c:pt>
                  <c:pt idx="1">
                    <c:v>1.3621804998918883</c:v>
                  </c:pt>
                  <c:pt idx="2">
                    <c:v>1.4623244705409455</c:v>
                  </c:pt>
                  <c:pt idx="3">
                    <c:v>1.244918241721692</c:v>
                  </c:pt>
                  <c:pt idx="4">
                    <c:v>1.330883165420617</c:v>
                  </c:pt>
                  <c:pt idx="5">
                    <c:v>1.449876842060337</c:v>
                  </c:pt>
                  <c:pt idx="6">
                    <c:v>1.4593907730869853</c:v>
                  </c:pt>
                  <c:pt idx="7">
                    <c:v>1.39155616898081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mir-tumor-chart.xlsx]Sheet1'!$F$215:$M$215</c:f>
              <c:numCache>
                <c:formatCode>General</c:formatCode>
                <c:ptCount val="8"/>
                <c:pt idx="0">
                  <c:v>19.237500000000001</c:v>
                </c:pt>
                <c:pt idx="1">
                  <c:v>19.387500000000003</c:v>
                </c:pt>
                <c:pt idx="2">
                  <c:v>19.512499999999999</c:v>
                </c:pt>
                <c:pt idx="3">
                  <c:v>19.612500000000001</c:v>
                </c:pt>
                <c:pt idx="4">
                  <c:v>19.637500000000003</c:v>
                </c:pt>
                <c:pt idx="5">
                  <c:v>19.725000000000001</c:v>
                </c:pt>
                <c:pt idx="6">
                  <c:v>19.8125</c:v>
                </c:pt>
                <c:pt idx="7">
                  <c:v>19.82499999999999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9DED-A34A-B187-E6EF68BCAC1E}"/>
            </c:ext>
          </c:extLst>
        </c:ser>
        <c:ser>
          <c:idx val="3"/>
          <c:order val="3"/>
          <c:tx>
            <c:v>miR-CVB3+CpGMel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[mir-tumor-chart.xlsx]Sheet1'!$O$216:$V$216</c:f>
                <c:numCache>
                  <c:formatCode>General</c:formatCode>
                  <c:ptCount val="8"/>
                  <c:pt idx="0">
                    <c:v>1.0646931147384338</c:v>
                  </c:pt>
                  <c:pt idx="1">
                    <c:v>0.96649218458151187</c:v>
                  </c:pt>
                  <c:pt idx="2">
                    <c:v>0.95234672557545186</c:v>
                  </c:pt>
                  <c:pt idx="3">
                    <c:v>1.0056092680559383</c:v>
                  </c:pt>
                  <c:pt idx="4">
                    <c:v>0.95758252162113255</c:v>
                  </c:pt>
                  <c:pt idx="5">
                    <c:v>0.89512568949840787</c:v>
                  </c:pt>
                  <c:pt idx="6">
                    <c:v>0.85690472882678936</c:v>
                  </c:pt>
                  <c:pt idx="7">
                    <c:v>0.9149551120917665</c:v>
                  </c:pt>
                </c:numCache>
              </c:numRef>
            </c:plus>
            <c:minus>
              <c:numRef>
                <c:f>'[mir-tumor-chart.xlsx]Sheet1'!$O$216:$V$216</c:f>
                <c:numCache>
                  <c:formatCode>General</c:formatCode>
                  <c:ptCount val="8"/>
                  <c:pt idx="0">
                    <c:v>1.0646931147384338</c:v>
                  </c:pt>
                  <c:pt idx="1">
                    <c:v>0.96649218458151187</c:v>
                  </c:pt>
                  <c:pt idx="2">
                    <c:v>0.95234672557545186</c:v>
                  </c:pt>
                  <c:pt idx="3">
                    <c:v>1.0056092680559383</c:v>
                  </c:pt>
                  <c:pt idx="4">
                    <c:v>0.95758252162113255</c:v>
                  </c:pt>
                  <c:pt idx="5">
                    <c:v>0.89512568949840787</c:v>
                  </c:pt>
                  <c:pt idx="6">
                    <c:v>0.85690472882678936</c:v>
                  </c:pt>
                  <c:pt idx="7">
                    <c:v>0.91495511209176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mir-tumor-chart.xlsx]Sheet1'!$F$216:$M$216</c:f>
              <c:numCache>
                <c:formatCode>General</c:formatCode>
                <c:ptCount val="8"/>
                <c:pt idx="0">
                  <c:v>18.574999999999996</c:v>
                </c:pt>
                <c:pt idx="1">
                  <c:v>18.637499999999999</c:v>
                </c:pt>
                <c:pt idx="2">
                  <c:v>18.587499999999999</c:v>
                </c:pt>
                <c:pt idx="3">
                  <c:v>18.637499999999996</c:v>
                </c:pt>
                <c:pt idx="4">
                  <c:v>18.837499999999999</c:v>
                </c:pt>
                <c:pt idx="5">
                  <c:v>18.8125</c:v>
                </c:pt>
                <c:pt idx="6">
                  <c:v>18.850000000000001</c:v>
                </c:pt>
                <c:pt idx="7">
                  <c:v>18.85000000000000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9DED-A34A-B187-E6EF68BCAC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99015432"/>
        <c:axId val="299013864"/>
      </c:lineChart>
      <c:catAx>
        <c:axId val="2990154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Day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9013864"/>
        <c:crosses val="autoZero"/>
        <c:auto val="1"/>
        <c:lblAlgn val="ctr"/>
        <c:lblOffset val="100"/>
        <c:noMultiLvlLbl val="0"/>
      </c:catAx>
      <c:valAx>
        <c:axId val="299013864"/>
        <c:scaling>
          <c:orientation val="minMax"/>
          <c:max val="25"/>
          <c:min val="1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Body weight (g)</a:t>
                </a:r>
              </a:p>
            </c:rich>
          </c:tx>
          <c:layout>
            <c:manualLayout>
              <c:xMode val="edge"/>
              <c:yMode val="edge"/>
              <c:x val="2.552809911328506E-2"/>
              <c:y val="0.2386279617348969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901543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8352065647050048"/>
          <c:y val="3.7097755735784249E-2"/>
          <c:w val="0.72859526294812305"/>
          <c:h val="0.304072359670125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0070C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3742-0049-877D-18E9FAAFDBBF}"/>
              </c:ext>
            </c:extLst>
          </c:dPt>
          <c:dPt>
            <c:idx val="2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3742-0049-877D-18E9FAAFDBBF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3742-0049-877D-18E9FAAFDBBF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J$87:$M$87</c:f>
                <c:numCache>
                  <c:formatCode>General</c:formatCode>
                  <c:ptCount val="4"/>
                  <c:pt idx="0">
                    <c:v>1E-3</c:v>
                  </c:pt>
                  <c:pt idx="1">
                    <c:v>7.2625340327781203</c:v>
                  </c:pt>
                  <c:pt idx="2">
                    <c:v>3.9537566574724217</c:v>
                  </c:pt>
                  <c:pt idx="3">
                    <c:v>2.3617817585512011</c:v>
                  </c:pt>
                </c:numCache>
              </c:numRef>
            </c:plus>
            <c:minus>
              <c:numRef>
                <c:f>Sheet2!$J$87:$M$87</c:f>
                <c:numCache>
                  <c:formatCode>General</c:formatCode>
                  <c:ptCount val="4"/>
                  <c:pt idx="0">
                    <c:v>1E-3</c:v>
                  </c:pt>
                  <c:pt idx="1">
                    <c:v>7.2625340327781203</c:v>
                  </c:pt>
                  <c:pt idx="2">
                    <c:v>3.9537566574724217</c:v>
                  </c:pt>
                  <c:pt idx="3">
                    <c:v>2.36178175855120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J$85:$M$85</c:f>
              <c:strCache>
                <c:ptCount val="4"/>
                <c:pt idx="0">
                  <c:v>Sham</c:v>
                </c:pt>
                <c:pt idx="1">
                  <c:v>CpGMel</c:v>
                </c:pt>
                <c:pt idx="2">
                  <c:v>miR-CVB3</c:v>
                </c:pt>
                <c:pt idx="3">
                  <c:v>miR-CVB3+CpGMel</c:v>
                </c:pt>
              </c:strCache>
            </c:strRef>
          </c:cat>
          <c:val>
            <c:numRef>
              <c:f>Sheet2!$J$86:$M$86</c:f>
              <c:numCache>
                <c:formatCode>General</c:formatCode>
                <c:ptCount val="4"/>
                <c:pt idx="0">
                  <c:v>1E-3</c:v>
                </c:pt>
                <c:pt idx="1">
                  <c:v>43.17</c:v>
                </c:pt>
                <c:pt idx="2">
                  <c:v>47.08</c:v>
                </c:pt>
                <c:pt idx="3">
                  <c:v>81.1800000000000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3742-0049-877D-18E9FAAFDB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010336"/>
        <c:axId val="299010728"/>
      </c:barChart>
      <c:catAx>
        <c:axId val="299010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9010728"/>
        <c:crosses val="autoZero"/>
        <c:auto val="1"/>
        <c:lblAlgn val="ctr"/>
        <c:lblOffset val="100"/>
        <c:noMultiLvlLbl val="0"/>
      </c:catAx>
      <c:valAx>
        <c:axId val="2990107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umor</a:t>
                </a:r>
                <a:r>
                  <a:rPr lang="en-US" baseline="0" dirty="0"/>
                  <a:t> suppression rate</a:t>
                </a:r>
                <a:r>
                  <a:rPr lang="en-US" dirty="0"/>
                  <a:t> %</a:t>
                </a:r>
              </a:p>
            </c:rich>
          </c:tx>
          <c:layout>
            <c:manualLayout>
              <c:xMode val="edge"/>
              <c:yMode val="edge"/>
              <c:x val="7.0357293919721684E-3"/>
              <c:y val="7.800653088957065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9010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drawing1.xml.rels><?xml version="1.0" encoding="UTF-8" standalone="yes"?>
<Relationships xmlns="http://schemas.openxmlformats.org/package/2006/relationships"><Relationship Id="rId1" Type="http://schemas.openxmlformats.org/officeDocument/2006/relationships/image" Target="../media/image2.pn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06475</cdr:y>
    </cdr:from>
    <cdr:to>
      <cdr:x>0.09881</cdr:x>
      <cdr:y>0.56643</cdr:y>
    </cdr:to>
    <cdr:pic>
      <cdr:nvPicPr>
        <cdr:cNvPr id="2" name="chart">
          <a:extLst xmlns:a="http://schemas.openxmlformats.org/drawingml/2006/main">
            <a:ext uri="{FF2B5EF4-FFF2-40B4-BE49-F238E27FC236}">
              <a16:creationId xmlns="" xmlns:a16="http://schemas.microsoft.com/office/drawing/2014/main" id="{8D384C72-4C2E-C4B4-AB05-75616C41DFAC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 rot="16200000">
          <a:off x="-4207333" y="582678"/>
          <a:ext cx="1085928" cy="200897"/>
        </a:xfrm>
        <a:prstGeom xmlns:a="http://schemas.openxmlformats.org/drawingml/2006/main" prst="rect">
          <a:avLst/>
        </a:prstGeom>
      </cdr:spPr>
    </cdr:pic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ECB364-00A4-48D7-B039-3E557FB0A689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02A4DD-EEC3-4453-9D3E-773A9B94F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10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4E6DBE-16E3-41FB-8B87-546FD636C4B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0017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295F0-3A65-489B-B322-A18521A2CF5D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BCC0C-07FC-469D-810A-56A04137B5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515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295F0-3A65-489B-B322-A18521A2CF5D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BCC0C-07FC-469D-810A-56A04137B5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351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295F0-3A65-489B-B322-A18521A2CF5D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BCC0C-07FC-469D-810A-56A04137B5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080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295F0-3A65-489B-B322-A18521A2CF5D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BCC0C-07FC-469D-810A-56A04137B5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620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295F0-3A65-489B-B322-A18521A2CF5D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BCC0C-07FC-469D-810A-56A04137B5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249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295F0-3A65-489B-B322-A18521A2CF5D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BCC0C-07FC-469D-810A-56A04137B5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839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295F0-3A65-489B-B322-A18521A2CF5D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BCC0C-07FC-469D-810A-56A04137B5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513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295F0-3A65-489B-B322-A18521A2CF5D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BCC0C-07FC-469D-810A-56A04137B5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475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295F0-3A65-489B-B322-A18521A2CF5D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BCC0C-07FC-469D-810A-56A04137B5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073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295F0-3A65-489B-B322-A18521A2CF5D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BCC0C-07FC-469D-810A-56A04137B5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0898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295F0-3A65-489B-B322-A18521A2CF5D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BCC0C-07FC-469D-810A-56A04137B5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435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4295F0-3A65-489B-B322-A18521A2CF5D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9BCC0C-07FC-469D-810A-56A04137B5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356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588738" y="876418"/>
            <a:ext cx="2129091" cy="3663484"/>
            <a:chOff x="3283168" y="1055849"/>
            <a:chExt cx="1041829" cy="238326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83168" y="2150398"/>
              <a:ext cx="1041829" cy="1288720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 rot="16200000">
              <a:off x="3190838" y="1874052"/>
              <a:ext cx="432207" cy="120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err="1">
                  <a:cs typeface="Arial" panose="020B0604020202020204" pitchFamily="34" charset="0"/>
                </a:rPr>
                <a:t>CpGMel</a:t>
              </a:r>
              <a:endParaRPr lang="en-US" sz="1000" b="1" dirty="0"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3279304" y="1717134"/>
              <a:ext cx="778198" cy="120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cs typeface="Arial" panose="020B0604020202020204" pitchFamily="34" charset="0"/>
                </a:rPr>
                <a:t>Filtered </a:t>
              </a:r>
              <a:r>
                <a:rPr lang="en-US" sz="1000" b="1" dirty="0" err="1">
                  <a:cs typeface="Arial" panose="020B0604020202020204" pitchFamily="34" charset="0"/>
                </a:rPr>
                <a:t>CpGMel</a:t>
              </a:r>
              <a:r>
                <a:rPr lang="en-US" sz="1000" b="1" dirty="0"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3665209" y="1830859"/>
              <a:ext cx="529312" cy="120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cs typeface="Arial" panose="020B0604020202020204" pitchFamily="34" charset="0"/>
                </a:rPr>
                <a:t>miR-CVB3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3641372" y="1545561"/>
              <a:ext cx="1099907" cy="120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cs typeface="Arial" panose="020B0604020202020204" pitchFamily="34" charset="0"/>
                </a:rPr>
                <a:t>Filtered miR-CVB3+CpGMel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F89D4A23-92E5-05AE-EAD0-3DB70BBFFF34}"/>
              </a:ext>
            </a:extLst>
          </p:cNvPr>
          <p:cNvSpPr txBox="1"/>
          <p:nvPr/>
        </p:nvSpPr>
        <p:spPr>
          <a:xfrm>
            <a:off x="1547789" y="5255308"/>
            <a:ext cx="85640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Supplemental Figure 1. </a:t>
            </a:r>
            <a:r>
              <a:rPr lang="en-US" sz="1600" dirty="0"/>
              <a:t>Examination of </a:t>
            </a:r>
            <a:r>
              <a:rPr lang="en-CA" sz="1600" dirty="0"/>
              <a:t>possible binding of </a:t>
            </a:r>
            <a:r>
              <a:rPr lang="en-CA" sz="1600" dirty="0" err="1"/>
              <a:t>CpGMel</a:t>
            </a:r>
            <a:r>
              <a:rPr lang="en-CA" sz="1600" dirty="0"/>
              <a:t> to the surface of miR-CVB3</a:t>
            </a:r>
            <a:r>
              <a:rPr lang="en-CA" sz="1600" dirty="0" smtClean="0"/>
              <a:t>.</a:t>
            </a:r>
            <a:endParaRPr lang="en-US" sz="16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91700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3380613" y="1820562"/>
            <a:ext cx="2213770" cy="2774515"/>
            <a:chOff x="1188720" y="113503"/>
            <a:chExt cx="2213770" cy="2429277"/>
          </a:xfrm>
        </p:grpSpPr>
        <p:sp>
          <p:nvSpPr>
            <p:cNvPr id="24" name="TextBox 23"/>
            <p:cNvSpPr txBox="1"/>
            <p:nvPr/>
          </p:nvSpPr>
          <p:spPr>
            <a:xfrm>
              <a:off x="2415727" y="113503"/>
              <a:ext cx="520323" cy="210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***</a:t>
              </a:r>
            </a:p>
          </p:txBody>
        </p:sp>
        <p:graphicFrame>
          <p:nvGraphicFramePr>
            <p:cNvPr id="41" name="Chart 4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95292750"/>
                </p:ext>
              </p:extLst>
            </p:nvPr>
          </p:nvGraphicFramePr>
          <p:xfrm>
            <a:off x="1188720" y="388619"/>
            <a:ext cx="2213770" cy="215416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42" name="Left Bracket 41"/>
            <p:cNvSpPr/>
            <p:nvPr/>
          </p:nvSpPr>
          <p:spPr>
            <a:xfrm rot="5400000">
              <a:off x="2449293" y="-287974"/>
              <a:ext cx="84331" cy="1152232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43" name="Left Bracket 42"/>
            <p:cNvSpPr/>
            <p:nvPr/>
          </p:nvSpPr>
          <p:spPr>
            <a:xfrm rot="5400000">
              <a:off x="2679014" y="22283"/>
              <a:ext cx="57921" cy="719198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44" name="Left Bracket 43"/>
            <p:cNvSpPr/>
            <p:nvPr/>
          </p:nvSpPr>
          <p:spPr>
            <a:xfrm rot="5400000">
              <a:off x="2820154" y="252645"/>
              <a:ext cx="46606" cy="430853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523161" y="243325"/>
              <a:ext cx="520323" cy="210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***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771517" y="311408"/>
              <a:ext cx="520323" cy="210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</a:t>
              </a:r>
            </a:p>
          </p:txBody>
        </p:sp>
        <p:sp>
          <p:nvSpPr>
            <p:cNvPr id="47" name="Left Bracket 46"/>
            <p:cNvSpPr/>
            <p:nvPr/>
          </p:nvSpPr>
          <p:spPr>
            <a:xfrm rot="5400000">
              <a:off x="2283888" y="379619"/>
              <a:ext cx="83241" cy="764931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48" name="Left Bracket 47"/>
            <p:cNvSpPr/>
            <p:nvPr/>
          </p:nvSpPr>
          <p:spPr>
            <a:xfrm rot="5400000">
              <a:off x="2482949" y="659851"/>
              <a:ext cx="45719" cy="40433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49" name="Left Bracket 48"/>
            <p:cNvSpPr/>
            <p:nvPr/>
          </p:nvSpPr>
          <p:spPr>
            <a:xfrm rot="5400000">
              <a:off x="2101675" y="1127343"/>
              <a:ext cx="65201" cy="382465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195882" y="586525"/>
              <a:ext cx="520323" cy="210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**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367868" y="705303"/>
              <a:ext cx="520323" cy="210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*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043481" y="1167177"/>
              <a:ext cx="520323" cy="210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</a:t>
              </a:r>
            </a:p>
          </p:txBody>
        </p:sp>
      </p:grpSp>
      <p:grpSp>
        <p:nvGrpSpPr>
          <p:cNvPr id="53" name="Group 52"/>
          <p:cNvGrpSpPr/>
          <p:nvPr/>
        </p:nvGrpSpPr>
        <p:grpSpPr>
          <a:xfrm>
            <a:off x="6023021" y="2046089"/>
            <a:ext cx="2033585" cy="2548988"/>
            <a:chOff x="4645495" y="449547"/>
            <a:chExt cx="2033217" cy="2548988"/>
          </a:xfrm>
        </p:grpSpPr>
        <p:graphicFrame>
          <p:nvGraphicFramePr>
            <p:cNvPr id="54" name="Chart 5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90057538"/>
                </p:ext>
              </p:extLst>
            </p:nvPr>
          </p:nvGraphicFramePr>
          <p:xfrm>
            <a:off x="4645495" y="833951"/>
            <a:ext cx="2033217" cy="21645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55" name="Left Bracket 54"/>
            <p:cNvSpPr/>
            <p:nvPr/>
          </p:nvSpPr>
          <p:spPr>
            <a:xfrm rot="5400000">
              <a:off x="6084594" y="593492"/>
              <a:ext cx="66727" cy="640938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56" name="Left Bracket 55"/>
            <p:cNvSpPr/>
            <p:nvPr/>
          </p:nvSpPr>
          <p:spPr>
            <a:xfrm rot="5400000">
              <a:off x="5732696" y="19288"/>
              <a:ext cx="93080" cy="1318379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602530" y="449547"/>
              <a:ext cx="520323" cy="210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***</a:t>
              </a:r>
            </a:p>
          </p:txBody>
        </p:sp>
        <p:sp>
          <p:nvSpPr>
            <p:cNvPr id="58" name="Left Bracket 57"/>
            <p:cNvSpPr/>
            <p:nvPr/>
          </p:nvSpPr>
          <p:spPr>
            <a:xfrm rot="5400000">
              <a:off x="5999382" y="394908"/>
              <a:ext cx="84749" cy="793338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5857795" y="624182"/>
              <a:ext cx="520323" cy="210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***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5948257" y="764056"/>
              <a:ext cx="520323" cy="210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*</a:t>
              </a:r>
            </a:p>
          </p:txBody>
        </p:sp>
      </p:grpSp>
      <p:sp>
        <p:nvSpPr>
          <p:cNvPr id="3" name="Rectangle 2"/>
          <p:cNvSpPr/>
          <p:nvPr/>
        </p:nvSpPr>
        <p:spPr>
          <a:xfrm>
            <a:off x="1639329" y="4960956"/>
            <a:ext cx="820488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Supplemental Figure </a:t>
            </a:r>
            <a:r>
              <a:rPr lang="en-US" b="1" dirty="0" smtClean="0"/>
              <a:t>2. </a:t>
            </a:r>
            <a:r>
              <a:rPr lang="en-US" dirty="0" err="1" smtClean="0"/>
              <a:t>qRT</a:t>
            </a:r>
            <a:r>
              <a:rPr lang="en-US" dirty="0" smtClean="0"/>
              <a:t>-PCR </a:t>
            </a:r>
            <a:r>
              <a:rPr lang="en-US" dirty="0"/>
              <a:t>was performed to determine the level of TNF-</a:t>
            </a:r>
            <a:r>
              <a:rPr lang="el-GR" dirty="0"/>
              <a:t>α</a:t>
            </a:r>
            <a:r>
              <a:rPr lang="en-US" dirty="0"/>
              <a:t> and IL-6 RNA in 4T1 cells after 6-hour incubation </a:t>
            </a:r>
            <a:r>
              <a:rPr lang="en-US" dirty="0" smtClean="0"/>
              <a:t>with </a:t>
            </a:r>
            <a:r>
              <a:rPr lang="en-US" dirty="0"/>
              <a:t>various agents </a:t>
            </a:r>
            <a:r>
              <a:rPr lang="en-US" dirty="0" smtClean="0"/>
              <a:t>(</a:t>
            </a:r>
            <a:r>
              <a:rPr lang="en-US" dirty="0"/>
              <a:t>n=3-5). Data were analyzed by one-way ANOVA followed by Tukey’s test to determine differences (*, p &lt; 0.05; **, p &lt; 0.01; ***, p &lt; </a:t>
            </a:r>
            <a:r>
              <a:rPr lang="en-US" dirty="0"/>
              <a:t>0.001, </a:t>
            </a:r>
            <a:r>
              <a:rPr lang="en-US" dirty="0" smtClean="0"/>
              <a:t>****, </a:t>
            </a:r>
            <a:r>
              <a:rPr lang="en-US" dirty="0"/>
              <a:t>p &lt; </a:t>
            </a:r>
            <a:r>
              <a:rPr lang="en-US" dirty="0" smtClean="0"/>
              <a:t>0.0001</a:t>
            </a:r>
            <a:r>
              <a:rPr lang="en-US" dirty="0"/>
              <a:t>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0621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290171" y="705790"/>
            <a:ext cx="7085959" cy="1457965"/>
            <a:chOff x="1590603" y="1001237"/>
            <a:chExt cx="7085959" cy="1457965"/>
          </a:xfrm>
        </p:grpSpPr>
        <p:grpSp>
          <p:nvGrpSpPr>
            <p:cNvPr id="4" name="Group 3"/>
            <p:cNvGrpSpPr/>
            <p:nvPr/>
          </p:nvGrpSpPr>
          <p:grpSpPr>
            <a:xfrm>
              <a:off x="1590603" y="1001237"/>
              <a:ext cx="5122085" cy="1375560"/>
              <a:chOff x="132505" y="4559983"/>
              <a:chExt cx="5122085" cy="1375560"/>
            </a:xfrm>
          </p:grpSpPr>
          <p:graphicFrame>
            <p:nvGraphicFramePr>
              <p:cNvPr id="5" name="Chart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74178942"/>
                  </p:ext>
                </p:extLst>
              </p:nvPr>
            </p:nvGraphicFramePr>
            <p:xfrm>
              <a:off x="132505" y="4562241"/>
              <a:ext cx="1534067" cy="132457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6" name="Chart 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46737590"/>
                  </p:ext>
                </p:extLst>
              </p:nvPr>
            </p:nvGraphicFramePr>
            <p:xfrm>
              <a:off x="3630446" y="4559983"/>
              <a:ext cx="1624144" cy="137555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7" name="Chart 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57648324"/>
                  </p:ext>
                </p:extLst>
              </p:nvPr>
            </p:nvGraphicFramePr>
            <p:xfrm>
              <a:off x="1883608" y="4585699"/>
              <a:ext cx="1623097" cy="134984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</p:grpSp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11752134"/>
                </p:ext>
              </p:extLst>
            </p:nvPr>
          </p:nvGraphicFramePr>
          <p:xfrm>
            <a:off x="6712688" y="1026953"/>
            <a:ext cx="1963874" cy="143224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8443708"/>
              </p:ext>
            </p:extLst>
          </p:nvPr>
        </p:nvGraphicFramePr>
        <p:xfrm>
          <a:off x="1560435" y="2943807"/>
          <a:ext cx="276783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1" name="Left Bracket 10"/>
          <p:cNvSpPr/>
          <p:nvPr/>
        </p:nvSpPr>
        <p:spPr>
          <a:xfrm rot="5400000">
            <a:off x="3159392" y="2274551"/>
            <a:ext cx="99535" cy="1438047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12" name="Left Bracket 11"/>
          <p:cNvSpPr/>
          <p:nvPr/>
        </p:nvSpPr>
        <p:spPr>
          <a:xfrm rot="5400000">
            <a:off x="3361793" y="2606019"/>
            <a:ext cx="104195" cy="1028584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13" name="Left Bracket 12"/>
          <p:cNvSpPr/>
          <p:nvPr/>
        </p:nvSpPr>
        <p:spPr>
          <a:xfrm rot="5400000">
            <a:off x="3684241" y="3017102"/>
            <a:ext cx="63764" cy="42412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14" name="Left Bracket 13"/>
          <p:cNvSpPr/>
          <p:nvPr/>
        </p:nvSpPr>
        <p:spPr>
          <a:xfrm rot="5400000">
            <a:off x="2692211" y="3443555"/>
            <a:ext cx="63764" cy="42412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15" name="Left Bracket 14"/>
          <p:cNvSpPr/>
          <p:nvPr/>
        </p:nvSpPr>
        <p:spPr>
          <a:xfrm rot="5400000">
            <a:off x="2943766" y="3055497"/>
            <a:ext cx="45719" cy="909186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16" name="TextBox 15"/>
          <p:cNvSpPr txBox="1"/>
          <p:nvPr/>
        </p:nvSpPr>
        <p:spPr>
          <a:xfrm>
            <a:off x="3085533" y="2790847"/>
            <a:ext cx="520323" cy="2399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65" dirty="0"/>
              <a:t>***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243901" y="2924579"/>
            <a:ext cx="520323" cy="2399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65" dirty="0"/>
              <a:t>***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525922" y="3063762"/>
            <a:ext cx="520323" cy="2399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65" dirty="0"/>
              <a:t>***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825371" y="3346927"/>
            <a:ext cx="520323" cy="2399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65" dirty="0"/>
              <a:t>***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584123" y="3480173"/>
            <a:ext cx="520323" cy="2399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65" dirty="0"/>
              <a:t>***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508457" y="436806"/>
            <a:ext cx="274434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b="1" dirty="0"/>
              <a:t>A</a:t>
            </a:r>
          </a:p>
        </p:txBody>
      </p:sp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6680779"/>
              </p:ext>
            </p:extLst>
          </p:nvPr>
        </p:nvGraphicFramePr>
        <p:xfrm>
          <a:off x="5447690" y="2896266"/>
          <a:ext cx="4450954" cy="23755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3" name="TextBox 22"/>
          <p:cNvSpPr txBox="1"/>
          <p:nvPr/>
        </p:nvSpPr>
        <p:spPr>
          <a:xfrm>
            <a:off x="5339157" y="2765551"/>
            <a:ext cx="263214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b="1" dirty="0"/>
              <a:t>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F89D4A23-92E5-05AE-EAD0-3DB70BBFFF34}"/>
              </a:ext>
            </a:extLst>
          </p:cNvPr>
          <p:cNvSpPr txBox="1"/>
          <p:nvPr/>
        </p:nvSpPr>
        <p:spPr>
          <a:xfrm>
            <a:off x="1442157" y="5647663"/>
            <a:ext cx="845648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/>
              <a:t>Supplemental Figure 3. </a:t>
            </a:r>
            <a:r>
              <a:rPr lang="en-US" sz="1600" dirty="0"/>
              <a:t>(A) Tumor volume curves for </a:t>
            </a:r>
            <a:r>
              <a:rPr lang="en-US" sz="1600" dirty="0" smtClean="0"/>
              <a:t>individual </a:t>
            </a:r>
            <a:r>
              <a:rPr lang="en-US" sz="1600" dirty="0"/>
              <a:t>mouse after indicated treatment (n=8/group). (B) Tumor suppression rate after different treatments. (C) Changes in body weights of mice after </a:t>
            </a:r>
            <a:r>
              <a:rPr lang="en-US" sz="1600" dirty="0" smtClean="0"/>
              <a:t>various </a:t>
            </a:r>
            <a:r>
              <a:rPr lang="en-US" sz="1600" dirty="0"/>
              <a:t>treatment. Data in this figure were analyzed by one-way ANOVA followed by Tukey’s test to determine differences (*, p &lt; 0.05; **, p &lt; 0.01; ***, p &lt; 0.001).</a:t>
            </a:r>
          </a:p>
          <a:p>
            <a:pPr algn="just"/>
            <a:endParaRPr lang="en-US" sz="1600" dirty="0"/>
          </a:p>
        </p:txBody>
      </p:sp>
      <p:sp>
        <p:nvSpPr>
          <p:cNvPr id="25" name="TextBox 24"/>
          <p:cNvSpPr txBox="1"/>
          <p:nvPr/>
        </p:nvSpPr>
        <p:spPr>
          <a:xfrm>
            <a:off x="1423218" y="2790847"/>
            <a:ext cx="274434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475727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4305566" y="1886835"/>
            <a:ext cx="2621903" cy="3056336"/>
            <a:chOff x="2803338" y="2148092"/>
            <a:chExt cx="2621903" cy="3056336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71437211"/>
                </p:ext>
              </p:extLst>
            </p:nvPr>
          </p:nvGraphicFramePr>
          <p:xfrm>
            <a:off x="2803338" y="2419815"/>
            <a:ext cx="2621903" cy="27846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4" name="Left Bracket 13"/>
            <p:cNvSpPr/>
            <p:nvPr/>
          </p:nvSpPr>
          <p:spPr>
            <a:xfrm rot="5400000">
              <a:off x="4307057" y="1631796"/>
              <a:ext cx="99535" cy="1438047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15" name="Left Bracket 14"/>
            <p:cNvSpPr/>
            <p:nvPr/>
          </p:nvSpPr>
          <p:spPr>
            <a:xfrm rot="5400000">
              <a:off x="4509458" y="1963264"/>
              <a:ext cx="104195" cy="1028584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16" name="Left Bracket 15"/>
            <p:cNvSpPr/>
            <p:nvPr/>
          </p:nvSpPr>
          <p:spPr>
            <a:xfrm rot="5400000">
              <a:off x="4831906" y="2374347"/>
              <a:ext cx="63764" cy="42412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17" name="Left Bracket 16"/>
            <p:cNvSpPr/>
            <p:nvPr/>
          </p:nvSpPr>
          <p:spPr>
            <a:xfrm rot="5400000">
              <a:off x="3847401" y="3014962"/>
              <a:ext cx="63764" cy="424120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18" name="Left Bracket 17"/>
            <p:cNvSpPr/>
            <p:nvPr/>
          </p:nvSpPr>
          <p:spPr>
            <a:xfrm rot="5400000">
              <a:off x="4091429" y="2664008"/>
              <a:ext cx="45719" cy="909186"/>
            </a:xfrm>
            <a:prstGeom prst="lef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48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233198" y="2148092"/>
              <a:ext cx="520323" cy="2399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**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391566" y="2281824"/>
              <a:ext cx="520323" cy="2399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**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673587" y="2421007"/>
              <a:ext cx="520323" cy="2399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**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973036" y="2928389"/>
              <a:ext cx="520323" cy="2399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**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708878" y="3075184"/>
              <a:ext cx="520323" cy="2399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65" dirty="0"/>
                <a:t>***</a:t>
              </a:r>
            </a:p>
          </p:txBody>
        </p:sp>
      </p:grpSp>
      <p:sp>
        <p:nvSpPr>
          <p:cNvPr id="25" name="Rectangle 24"/>
          <p:cNvSpPr/>
          <p:nvPr/>
        </p:nvSpPr>
        <p:spPr>
          <a:xfrm>
            <a:off x="1412472" y="5157240"/>
            <a:ext cx="930262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l Figure 4. </a:t>
            </a:r>
            <a:r>
              <a:rPr lang="en-US" dirty="0"/>
              <a:t>Suppression rates of different treatments against the distant tumor (</a:t>
            </a:r>
            <a:r>
              <a:rPr lang="en-US" i="1" dirty="0"/>
              <a:t>n</a:t>
            </a:r>
            <a:r>
              <a:rPr lang="en-US" dirty="0"/>
              <a:t> = 5 mice for each group). Data were analyzed by one-way ANOVA followed by Tukey’s test to determine differences (*, p &lt; 0.05; **, p &lt; 0.01; ***, p &lt; 0.001)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87250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9302330"/>
              </p:ext>
            </p:extLst>
          </p:nvPr>
        </p:nvGraphicFramePr>
        <p:xfrm>
          <a:off x="2910788" y="1446022"/>
          <a:ext cx="6221134" cy="28836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/>
          <p:cNvSpPr/>
          <p:nvPr/>
        </p:nvSpPr>
        <p:spPr>
          <a:xfrm>
            <a:off x="2422849" y="4657636"/>
            <a:ext cx="737429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Supplemental Figure 5. </a:t>
            </a:r>
            <a:r>
              <a:rPr lang="en-US" dirty="0"/>
              <a:t>Changes in body of </a:t>
            </a:r>
            <a:r>
              <a:rPr lang="en-US" dirty="0" smtClean="0"/>
              <a:t>mice (n=3) </a:t>
            </a:r>
            <a:r>
              <a:rPr lang="en-US" dirty="0"/>
              <a:t>after various </a:t>
            </a:r>
            <a:r>
              <a:rPr lang="en-US" dirty="0" smtClean="0"/>
              <a:t>treatments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47381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3</TotalTime>
  <Words>299</Words>
  <Application>Microsoft Office PowerPoint</Application>
  <PresentationFormat>Widescreen</PresentationFormat>
  <Paragraphs>53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entre for Heart Lung Innov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rhossein Bahreyni</dc:creator>
  <cp:lastModifiedBy>Amirhossein Bahreyni</cp:lastModifiedBy>
  <cp:revision>22</cp:revision>
  <dcterms:created xsi:type="dcterms:W3CDTF">2022-07-30T21:30:18Z</dcterms:created>
  <dcterms:modified xsi:type="dcterms:W3CDTF">2022-08-06T20:22:21Z</dcterms:modified>
</cp:coreProperties>
</file>